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rels" ContentType="application/vnd.openxmlformats-package.relationships+xml"/>
  <Default Extension="tiff" ContentType="image/tiff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15"/>
  </p:notesMasterIdLst>
  <p:sldIdLst>
    <p:sldId id="489" r:id="rId5"/>
    <p:sldId id="485" r:id="rId6"/>
    <p:sldId id="486" r:id="rId7"/>
    <p:sldId id="352" r:id="rId8"/>
    <p:sldId id="380" r:id="rId9"/>
    <p:sldId id="487" r:id="rId10"/>
    <p:sldId id="473" r:id="rId11"/>
    <p:sldId id="321" r:id="rId12"/>
    <p:sldId id="478" r:id="rId13"/>
    <p:sldId id="488" r:id="rId14"/>
  </p:sldIdLst>
  <p:sldSz cx="6858000" cy="9906000" type="A4"/>
  <p:notesSz cx="6858000" cy="9144000"/>
  <p:defaultTextStyle>
    <a:defPPr>
      <a:defRPr lang="en-GB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F7F7F"/>
    <a:srgbClr val="FFB2B2"/>
    <a:srgbClr val="FF0066"/>
    <a:srgbClr val="FFAC0A"/>
    <a:srgbClr val="F4671E"/>
    <a:srgbClr val="FF7FB2"/>
    <a:srgbClr val="87BFBF"/>
    <a:srgbClr val="107F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5" autoAdjust="0"/>
    <p:restoredTop sz="96667" autoAdjust="0"/>
  </p:normalViewPr>
  <p:slideViewPr>
    <p:cSldViewPr snapToGrid="0">
      <p:cViewPr varScale="1">
        <p:scale>
          <a:sx n="57" d="100"/>
          <a:sy n="57" d="100"/>
        </p:scale>
        <p:origin x="2539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94" d="100"/>
        <a:sy n="194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viewProps" Target="viewProps.xml"/><Relationship Id="rId2" Type="http://schemas.openxmlformats.org/officeDocument/2006/relationships/customXml" Target="../customXml/item2.xml"/><Relationship Id="rId16" Type="http://schemas.openxmlformats.org/officeDocument/2006/relationships/presProps" Target="presProps.xml"/><Relationship Id="rId20" Type="http://schemas.microsoft.com/office/2016/11/relationships/changesInfo" Target="changesInfos/changesInfo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6.xml"/><Relationship Id="rId19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ja Miladinovic" userId="84388fe1-2c77-41ab-8c52-80bb7609df32" providerId="ADAL" clId="{C04BC26E-1581-41CE-8FCC-D1BDA69C04B3}"/>
    <pc:docChg chg="undo custSel modSld">
      <pc:chgData name="Maja Miladinovic" userId="84388fe1-2c77-41ab-8c52-80bb7609df32" providerId="ADAL" clId="{C04BC26E-1581-41CE-8FCC-D1BDA69C04B3}" dt="2025-11-20T15:52:35.028" v="36" actId="20577"/>
      <pc:docMkLst>
        <pc:docMk/>
      </pc:docMkLst>
      <pc:sldChg chg="modSp mod">
        <pc:chgData name="Maja Miladinovic" userId="84388fe1-2c77-41ab-8c52-80bb7609df32" providerId="ADAL" clId="{C04BC26E-1581-41CE-8FCC-D1BDA69C04B3}" dt="2025-11-20T15:52:25.484" v="30" actId="20577"/>
        <pc:sldMkLst>
          <pc:docMk/>
          <pc:sldMk cId="128478075" sldId="321"/>
        </pc:sldMkLst>
        <pc:spChg chg="mod">
          <ac:chgData name="Maja Miladinovic" userId="84388fe1-2c77-41ab-8c52-80bb7609df32" providerId="ADAL" clId="{C04BC26E-1581-41CE-8FCC-D1BDA69C04B3}" dt="2025-11-20T15:52:25.484" v="30" actId="20577"/>
          <ac:spMkLst>
            <pc:docMk/>
            <pc:sldMk cId="128478075" sldId="321"/>
            <ac:spMk id="17" creationId="{8756E53B-E8DE-8D47-B2DF-3A162BAAF2A3}"/>
          </ac:spMkLst>
        </pc:spChg>
      </pc:sldChg>
      <pc:sldChg chg="modSp mod">
        <pc:chgData name="Maja Miladinovic" userId="84388fe1-2c77-41ab-8c52-80bb7609df32" providerId="ADAL" clId="{C04BC26E-1581-41CE-8FCC-D1BDA69C04B3}" dt="2025-11-20T15:51:56.790" v="13" actId="20577"/>
        <pc:sldMkLst>
          <pc:docMk/>
          <pc:sldMk cId="1983067501" sldId="352"/>
        </pc:sldMkLst>
        <pc:spChg chg="mod">
          <ac:chgData name="Maja Miladinovic" userId="84388fe1-2c77-41ab-8c52-80bb7609df32" providerId="ADAL" clId="{C04BC26E-1581-41CE-8FCC-D1BDA69C04B3}" dt="2025-11-20T15:51:56.790" v="13" actId="20577"/>
          <ac:spMkLst>
            <pc:docMk/>
            <pc:sldMk cId="1983067501" sldId="352"/>
            <ac:spMk id="11" creationId="{68A70B02-7EB9-0661-02E3-D7FEEE1A3328}"/>
          </ac:spMkLst>
        </pc:spChg>
      </pc:sldChg>
      <pc:sldChg chg="modSp mod">
        <pc:chgData name="Maja Miladinovic" userId="84388fe1-2c77-41ab-8c52-80bb7609df32" providerId="ADAL" clId="{C04BC26E-1581-41CE-8FCC-D1BDA69C04B3}" dt="2025-11-20T15:52:02.214" v="16" actId="20577"/>
        <pc:sldMkLst>
          <pc:docMk/>
          <pc:sldMk cId="1893652329" sldId="380"/>
        </pc:sldMkLst>
        <pc:spChg chg="mod">
          <ac:chgData name="Maja Miladinovic" userId="84388fe1-2c77-41ab-8c52-80bb7609df32" providerId="ADAL" clId="{C04BC26E-1581-41CE-8FCC-D1BDA69C04B3}" dt="2025-11-20T15:52:02.214" v="16" actId="20577"/>
          <ac:spMkLst>
            <pc:docMk/>
            <pc:sldMk cId="1893652329" sldId="380"/>
            <ac:spMk id="66" creationId="{68A70B02-7EB9-0661-02E3-D7FEEE1A3328}"/>
          </ac:spMkLst>
        </pc:spChg>
      </pc:sldChg>
      <pc:sldChg chg="modSp mod">
        <pc:chgData name="Maja Miladinovic" userId="84388fe1-2c77-41ab-8c52-80bb7609df32" providerId="ADAL" clId="{C04BC26E-1581-41CE-8FCC-D1BDA69C04B3}" dt="2025-11-20T15:52:20.098" v="27" actId="20577"/>
        <pc:sldMkLst>
          <pc:docMk/>
          <pc:sldMk cId="664335424" sldId="473"/>
        </pc:sldMkLst>
        <pc:spChg chg="mod">
          <ac:chgData name="Maja Miladinovic" userId="84388fe1-2c77-41ab-8c52-80bb7609df32" providerId="ADAL" clId="{C04BC26E-1581-41CE-8FCC-D1BDA69C04B3}" dt="2025-11-20T15:52:20.098" v="27" actId="20577"/>
          <ac:spMkLst>
            <pc:docMk/>
            <pc:sldMk cId="664335424" sldId="473"/>
            <ac:spMk id="4" creationId="{8756E53B-E8DE-8D47-B2DF-3A162BAAF2A3}"/>
          </ac:spMkLst>
        </pc:spChg>
      </pc:sldChg>
      <pc:sldChg chg="modSp mod">
        <pc:chgData name="Maja Miladinovic" userId="84388fe1-2c77-41ab-8c52-80bb7609df32" providerId="ADAL" clId="{C04BC26E-1581-41CE-8FCC-D1BDA69C04B3}" dt="2025-11-20T15:52:30.652" v="33" actId="20577"/>
        <pc:sldMkLst>
          <pc:docMk/>
          <pc:sldMk cId="583927687" sldId="478"/>
        </pc:sldMkLst>
        <pc:spChg chg="mod">
          <ac:chgData name="Maja Miladinovic" userId="84388fe1-2c77-41ab-8c52-80bb7609df32" providerId="ADAL" clId="{C04BC26E-1581-41CE-8FCC-D1BDA69C04B3}" dt="2025-11-20T15:52:30.652" v="33" actId="20577"/>
          <ac:spMkLst>
            <pc:docMk/>
            <pc:sldMk cId="583927687" sldId="478"/>
            <ac:spMk id="11" creationId="{68A70B02-7EB9-0661-02E3-D7FEEE1A3328}"/>
          </ac:spMkLst>
        </pc:spChg>
      </pc:sldChg>
      <pc:sldChg chg="modSp mod">
        <pc:chgData name="Maja Miladinovic" userId="84388fe1-2c77-41ab-8c52-80bb7609df32" providerId="ADAL" clId="{C04BC26E-1581-41CE-8FCC-D1BDA69C04B3}" dt="2025-11-20T15:51:36.149" v="5" actId="20577"/>
        <pc:sldMkLst>
          <pc:docMk/>
          <pc:sldMk cId="1135600127" sldId="485"/>
        </pc:sldMkLst>
        <pc:spChg chg="mod">
          <ac:chgData name="Maja Miladinovic" userId="84388fe1-2c77-41ab-8c52-80bb7609df32" providerId="ADAL" clId="{C04BC26E-1581-41CE-8FCC-D1BDA69C04B3}" dt="2025-11-20T15:51:36.149" v="5" actId="20577"/>
          <ac:spMkLst>
            <pc:docMk/>
            <pc:sldMk cId="1135600127" sldId="485"/>
            <ac:spMk id="80" creationId="{68A70B02-7EB9-0661-02E3-D7FEEE1A3328}"/>
          </ac:spMkLst>
        </pc:spChg>
      </pc:sldChg>
      <pc:sldChg chg="modSp mod">
        <pc:chgData name="Maja Miladinovic" userId="84388fe1-2c77-41ab-8c52-80bb7609df32" providerId="ADAL" clId="{C04BC26E-1581-41CE-8FCC-D1BDA69C04B3}" dt="2025-11-20T15:51:46.551" v="9" actId="20577"/>
        <pc:sldMkLst>
          <pc:docMk/>
          <pc:sldMk cId="1791831466" sldId="486"/>
        </pc:sldMkLst>
        <pc:spChg chg="mod">
          <ac:chgData name="Maja Miladinovic" userId="84388fe1-2c77-41ab-8c52-80bb7609df32" providerId="ADAL" clId="{C04BC26E-1581-41CE-8FCC-D1BDA69C04B3}" dt="2025-11-20T15:51:46.551" v="9" actId="20577"/>
          <ac:spMkLst>
            <pc:docMk/>
            <pc:sldMk cId="1791831466" sldId="486"/>
            <ac:spMk id="80" creationId="{68A70B02-7EB9-0661-02E3-D7FEEE1A3328}"/>
          </ac:spMkLst>
        </pc:spChg>
      </pc:sldChg>
      <pc:sldChg chg="modSp mod">
        <pc:chgData name="Maja Miladinovic" userId="84388fe1-2c77-41ab-8c52-80bb7609df32" providerId="ADAL" clId="{C04BC26E-1581-41CE-8FCC-D1BDA69C04B3}" dt="2025-11-20T15:52:07.387" v="19" actId="20577"/>
        <pc:sldMkLst>
          <pc:docMk/>
          <pc:sldMk cId="1549447731" sldId="487"/>
        </pc:sldMkLst>
        <pc:spChg chg="mod">
          <ac:chgData name="Maja Miladinovic" userId="84388fe1-2c77-41ab-8c52-80bb7609df32" providerId="ADAL" clId="{C04BC26E-1581-41CE-8FCC-D1BDA69C04B3}" dt="2025-11-20T15:52:07.387" v="19" actId="20577"/>
          <ac:spMkLst>
            <pc:docMk/>
            <pc:sldMk cId="1549447731" sldId="487"/>
            <ac:spMk id="66" creationId="{68A70B02-7EB9-0661-02E3-D7FEEE1A3328}"/>
          </ac:spMkLst>
        </pc:spChg>
      </pc:sldChg>
      <pc:sldChg chg="modSp mod">
        <pc:chgData name="Maja Miladinovic" userId="84388fe1-2c77-41ab-8c52-80bb7609df32" providerId="ADAL" clId="{C04BC26E-1581-41CE-8FCC-D1BDA69C04B3}" dt="2025-11-20T15:52:35.028" v="36" actId="20577"/>
        <pc:sldMkLst>
          <pc:docMk/>
          <pc:sldMk cId="1165427872" sldId="488"/>
        </pc:sldMkLst>
        <pc:spChg chg="mod">
          <ac:chgData name="Maja Miladinovic" userId="84388fe1-2c77-41ab-8c52-80bb7609df32" providerId="ADAL" clId="{C04BC26E-1581-41CE-8FCC-D1BDA69C04B3}" dt="2025-11-20T15:52:35.028" v="36" actId="20577"/>
          <ac:spMkLst>
            <pc:docMk/>
            <pc:sldMk cId="1165427872" sldId="488"/>
            <ac:spMk id="11" creationId="{68A70B02-7EB9-0661-02E3-D7FEEE1A3328}"/>
          </ac:spMkLst>
        </pc:spChg>
      </pc:sldChg>
      <pc:sldChg chg="modSp mod">
        <pc:chgData name="Maja Miladinovic" userId="84388fe1-2c77-41ab-8c52-80bb7609df32" providerId="ADAL" clId="{C04BC26E-1581-41CE-8FCC-D1BDA69C04B3}" dt="2025-11-20T15:51:19.764" v="1" actId="20577"/>
        <pc:sldMkLst>
          <pc:docMk/>
          <pc:sldMk cId="1977342501" sldId="489"/>
        </pc:sldMkLst>
        <pc:spChg chg="mod">
          <ac:chgData name="Maja Miladinovic" userId="84388fe1-2c77-41ab-8c52-80bb7609df32" providerId="ADAL" clId="{C04BC26E-1581-41CE-8FCC-D1BDA69C04B3}" dt="2025-11-20T15:51:19.764" v="1" actId="20577"/>
          <ac:spMkLst>
            <pc:docMk/>
            <pc:sldMk cId="1977342501" sldId="489"/>
            <ac:spMk id="3" creationId="{BB152B37-4DB8-3A9C-16E7-197DAB5E746E}"/>
          </ac:spMkLst>
        </pc:spChg>
      </pc:sldChg>
    </pc:docChg>
  </pc:docChgLst>
  <pc:docChgLst>
    <pc:chgData name="Kevin Gaston (staff)" userId="231217b6-9f3d-47e0-bb67-92c954e7b517" providerId="ADAL" clId="{7C9CFB93-9FDA-452B-B37C-25B4A4AC99D8}"/>
    <pc:docChg chg="custSel addSld modSld sldOrd">
      <pc:chgData name="Kevin Gaston (staff)" userId="231217b6-9f3d-47e0-bb67-92c954e7b517" providerId="ADAL" clId="{7C9CFB93-9FDA-452B-B37C-25B4A4AC99D8}" dt="2025-11-13T15:35:31.243" v="18" actId="1076"/>
      <pc:docMkLst>
        <pc:docMk/>
      </pc:docMkLst>
      <pc:sldChg chg="addSp modSp new mod ord">
        <pc:chgData name="Kevin Gaston (staff)" userId="231217b6-9f3d-47e0-bb67-92c954e7b517" providerId="ADAL" clId="{7C9CFB93-9FDA-452B-B37C-25B4A4AC99D8}" dt="2025-11-13T15:35:31.243" v="18" actId="1076"/>
        <pc:sldMkLst>
          <pc:docMk/>
          <pc:sldMk cId="1977342501" sldId="489"/>
        </pc:sldMkLst>
        <pc:spChg chg="add mod">
          <ac:chgData name="Kevin Gaston (staff)" userId="231217b6-9f3d-47e0-bb67-92c954e7b517" providerId="ADAL" clId="{7C9CFB93-9FDA-452B-B37C-25B4A4AC99D8}" dt="2025-11-13T15:33:51.156" v="4" actId="27636"/>
          <ac:spMkLst>
            <pc:docMk/>
            <pc:sldMk cId="1977342501" sldId="489"/>
            <ac:spMk id="3" creationId="{BB152B37-4DB8-3A9C-16E7-197DAB5E746E}"/>
          </ac:spMkLst>
        </pc:spChg>
        <pc:spChg chg="mod">
          <ac:chgData name="Kevin Gaston (staff)" userId="231217b6-9f3d-47e0-bb67-92c954e7b517" providerId="ADAL" clId="{7C9CFB93-9FDA-452B-B37C-25B4A4AC99D8}" dt="2025-11-13T15:34:37.549" v="8" actId="14100"/>
          <ac:spMkLst>
            <pc:docMk/>
            <pc:sldMk cId="1977342501" sldId="489"/>
            <ac:spMk id="6" creationId="{41EBF81E-3A70-0673-3668-A0C4B631579C}"/>
          </ac:spMkLst>
        </pc:spChg>
        <pc:spChg chg="mod">
          <ac:chgData name="Kevin Gaston (staff)" userId="231217b6-9f3d-47e0-bb67-92c954e7b517" providerId="ADAL" clId="{7C9CFB93-9FDA-452B-B37C-25B4A4AC99D8}" dt="2025-11-13T15:34:37.549" v="8" actId="14100"/>
          <ac:spMkLst>
            <pc:docMk/>
            <pc:sldMk cId="1977342501" sldId="489"/>
            <ac:spMk id="7" creationId="{2F926FF9-C433-1BA6-111D-AFE7B7C65942}"/>
          </ac:spMkLst>
        </pc:spChg>
        <pc:spChg chg="add mod">
          <ac:chgData name="Kevin Gaston (staff)" userId="231217b6-9f3d-47e0-bb67-92c954e7b517" providerId="ADAL" clId="{7C9CFB93-9FDA-452B-B37C-25B4A4AC99D8}" dt="2025-11-13T15:35:31.243" v="18" actId="1076"/>
          <ac:spMkLst>
            <pc:docMk/>
            <pc:sldMk cId="1977342501" sldId="489"/>
            <ac:spMk id="8" creationId="{8A2D6E2F-60E2-F912-05E8-334594ABE332}"/>
          </ac:spMkLst>
        </pc:spChg>
        <pc:spChg chg="add mod">
          <ac:chgData name="Kevin Gaston (staff)" userId="231217b6-9f3d-47e0-bb67-92c954e7b517" providerId="ADAL" clId="{7C9CFB93-9FDA-452B-B37C-25B4A4AC99D8}" dt="2025-11-13T15:35:19.581" v="16" actId="1076"/>
          <ac:spMkLst>
            <pc:docMk/>
            <pc:sldMk cId="1977342501" sldId="489"/>
            <ac:spMk id="9" creationId="{E7F11C5D-558A-B9DD-20C6-23B2F802A1F6}"/>
          </ac:spMkLst>
        </pc:spChg>
        <pc:grpChg chg="add mod">
          <ac:chgData name="Kevin Gaston (staff)" userId="231217b6-9f3d-47e0-bb67-92c954e7b517" providerId="ADAL" clId="{7C9CFB93-9FDA-452B-B37C-25B4A4AC99D8}" dt="2025-11-13T15:34:47.269" v="9" actId="1076"/>
          <ac:grpSpMkLst>
            <pc:docMk/>
            <pc:sldMk cId="1977342501" sldId="489"/>
            <ac:grpSpMk id="4" creationId="{50EFB63A-FD80-F43D-662C-DB22365C2C0B}"/>
          </ac:grpSpMkLst>
        </pc:grpChg>
        <pc:graphicFrameChg chg="mod">
          <ac:chgData name="Kevin Gaston (staff)" userId="231217b6-9f3d-47e0-bb67-92c954e7b517" providerId="ADAL" clId="{7C9CFB93-9FDA-452B-B37C-25B4A4AC99D8}" dt="2025-11-13T15:34:37.549" v="8" actId="14100"/>
          <ac:graphicFrameMkLst>
            <pc:docMk/>
            <pc:sldMk cId="1977342501" sldId="489"/>
            <ac:graphicFrameMk id="5" creationId="{BC1A0F62-7271-A868-F2B7-4B39348F8978}"/>
          </ac:graphicFrameMkLst>
        </pc:graphicFrameChg>
        <pc:graphicFrameChg chg="add mod">
          <ac:chgData name="Kevin Gaston (staff)" userId="231217b6-9f3d-47e0-bb67-92c954e7b517" providerId="ADAL" clId="{7C9CFB93-9FDA-452B-B37C-25B4A4AC99D8}" dt="2025-11-13T15:35:17.346" v="15" actId="1076"/>
          <ac:graphicFrameMkLst>
            <pc:docMk/>
            <pc:sldMk cId="1977342501" sldId="489"/>
            <ac:graphicFrameMk id="10" creationId="{76306708-B74C-1718-D078-B74BB5C3315F}"/>
          </ac:graphicFrameMkLst>
        </pc:graphicFrameChg>
        <pc:picChg chg="add mod">
          <ac:chgData name="Kevin Gaston (staff)" userId="231217b6-9f3d-47e0-bb67-92c954e7b517" providerId="ADAL" clId="{7C9CFB93-9FDA-452B-B37C-25B4A4AC99D8}" dt="2025-11-13T15:33:56.188" v="5" actId="1076"/>
          <ac:picMkLst>
            <pc:docMk/>
            <pc:sldMk cId="1977342501" sldId="489"/>
            <ac:picMk id="2" creationId="{E0C84D2B-5921-A7F7-B488-85B3142C0404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A73D5EB-8969-4638-804C-BBD0D6753354}" type="datetimeFigureOut">
              <a:rPr lang="en-GB" smtClean="0"/>
              <a:t>20/11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2200" y="1143000"/>
            <a:ext cx="21336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72CDA0-E7BC-479E-B6A4-91714DB2F1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9294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5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en-GB"/>
              <a:t>Click to edit Master title style</a:t>
            </a:r>
            <a:endParaRPr lang="en-GB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GB"/>
              <a:t>Click to edit Master subtitle style</a:t>
            </a:r>
            <a:endParaRPr lang="en-GB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GB" smtClean="0"/>
              <a:t>20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5387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GB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GB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GB" smtClean="0"/>
              <a:t>20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2905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GB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GB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GB" smtClean="0"/>
              <a:t>20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9445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GB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GB" smtClean="0"/>
              <a:t>20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9138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en-GB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82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82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GB" smtClean="0"/>
              <a:t>20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1524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GB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GB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GB" smtClean="0"/>
              <a:t>20/11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3092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3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6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GB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6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GB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GB" smtClean="0"/>
              <a:t>20/11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3172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GB" smtClean="0"/>
              <a:t>20/11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0312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GB" smtClean="0"/>
              <a:t>20/11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6388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GB"/>
              <a:t>Click to edit Master title style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1"/>
            <a:ext cx="3471863" cy="7039680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2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GB" smtClean="0"/>
              <a:t>20/11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1841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GB"/>
              <a:t>Click to edit Master title style</a:t>
            </a:r>
            <a:endParaRPr lang="en-GB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1"/>
            <a:ext cx="3471863" cy="7039680"/>
          </a:xfrm>
        </p:spPr>
        <p:txBody>
          <a:bodyPr anchor="t"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r>
              <a:rPr lang="en-GB"/>
              <a:t>Click icon to add picture</a:t>
            </a:r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2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GB" smtClean="0"/>
              <a:t>20/11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8958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3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GB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6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46CE7D5-CF57-46EF-B807-FDD0502418D4}" type="datetimeFigureOut">
              <a:rPr lang="en-GB" smtClean="0"/>
              <a:t>20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6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6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30EA680-D336-4FF7-8B7A-9848BB0A1C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0954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GB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2.wm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tiff"/><Relationship Id="rId2" Type="http://schemas.openxmlformats.org/officeDocument/2006/relationships/image" Target="../media/image37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9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tiff"/><Relationship Id="rId3" Type="http://schemas.openxmlformats.org/officeDocument/2006/relationships/image" Target="../media/image5.tiff"/><Relationship Id="rId7" Type="http://schemas.openxmlformats.org/officeDocument/2006/relationships/image" Target="../media/image9.tiff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tiff"/><Relationship Id="rId4" Type="http://schemas.openxmlformats.org/officeDocument/2006/relationships/image" Target="../media/image6.tiff"/><Relationship Id="rId9" Type="http://schemas.openxmlformats.org/officeDocument/2006/relationships/image" Target="../media/image11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iff"/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7.tiff"/><Relationship Id="rId4" Type="http://schemas.openxmlformats.org/officeDocument/2006/relationships/image" Target="../media/image16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tiff"/><Relationship Id="rId2" Type="http://schemas.openxmlformats.org/officeDocument/2006/relationships/image" Target="../media/image18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tiff"/><Relationship Id="rId5" Type="http://schemas.openxmlformats.org/officeDocument/2006/relationships/image" Target="../media/image21.tiff"/><Relationship Id="rId4" Type="http://schemas.openxmlformats.org/officeDocument/2006/relationships/image" Target="../media/image20.tif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tiff"/><Relationship Id="rId3" Type="http://schemas.openxmlformats.org/officeDocument/2006/relationships/image" Target="../media/image24.tiff"/><Relationship Id="rId7" Type="http://schemas.openxmlformats.org/officeDocument/2006/relationships/image" Target="../media/image28.tiff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tiff"/><Relationship Id="rId5" Type="http://schemas.openxmlformats.org/officeDocument/2006/relationships/image" Target="../media/image26.tiff"/><Relationship Id="rId4" Type="http://schemas.openxmlformats.org/officeDocument/2006/relationships/image" Target="../media/image25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tiff"/><Relationship Id="rId2" Type="http://schemas.openxmlformats.org/officeDocument/2006/relationships/image" Target="../media/image30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tiff"/><Relationship Id="rId2" Type="http://schemas.openxmlformats.org/officeDocument/2006/relationships/image" Target="../media/image33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6.tiff"/><Relationship Id="rId4" Type="http://schemas.openxmlformats.org/officeDocument/2006/relationships/image" Target="../media/image3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0C84D2B-5921-A7F7-B488-85B3142C0404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29054" r="39419"/>
          <a:stretch>
            <a:fillRect/>
          </a:stretch>
        </p:blipFill>
        <p:spPr>
          <a:xfrm>
            <a:off x="757851" y="1459144"/>
            <a:ext cx="898800" cy="1026181"/>
          </a:xfrm>
          <a:prstGeom prst="rect">
            <a:avLst/>
          </a:prstGeom>
        </p:spPr>
      </p:pic>
      <p:sp>
        <p:nvSpPr>
          <p:cNvPr id="3" name="Title 1">
            <a:extLst>
              <a:ext uri="{FF2B5EF4-FFF2-40B4-BE49-F238E27FC236}">
                <a16:creationId xmlns:a16="http://schemas.microsoft.com/office/drawing/2014/main" id="{BB152B37-4DB8-3A9C-16E7-197DAB5E746E}"/>
              </a:ext>
            </a:extLst>
          </p:cNvPr>
          <p:cNvSpPr txBox="1">
            <a:spLocks/>
          </p:cNvSpPr>
          <p:nvPr/>
        </p:nvSpPr>
        <p:spPr>
          <a:xfrm>
            <a:off x="207820" y="671139"/>
            <a:ext cx="6212128" cy="788005"/>
          </a:xfrm>
          <a:prstGeom prst="rect">
            <a:avLst/>
          </a:prstGeom>
        </p:spPr>
        <p:txBody>
          <a:bodyPr>
            <a:normAutofit fontScale="82500" lnSpcReduction="2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100000"/>
              </a:lnSpc>
            </a:pPr>
            <a:r>
              <a:rPr lang="en-GB" sz="1200" b="1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13 Drug screening and validation of Niclosamide using CCA cell lines and primary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iliary epithelial cells.</a:t>
            </a:r>
            <a:b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50EFB63A-FD80-F43D-662C-DB22365C2C0B}"/>
              </a:ext>
            </a:extLst>
          </p:cNvPr>
          <p:cNvGrpSpPr>
            <a:grpSpLocks noChangeAspect="1"/>
          </p:cNvGrpSpPr>
          <p:nvPr/>
        </p:nvGrpSpPr>
        <p:grpSpPr>
          <a:xfrm>
            <a:off x="552699" y="2859495"/>
            <a:ext cx="4662934" cy="2598642"/>
            <a:chOff x="332" y="165"/>
            <a:chExt cx="10925" cy="6088"/>
          </a:xfrm>
        </p:grpSpPr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BC1A0F62-7271-A868-F2B7-4B39348F8978}"/>
                </a:ext>
              </a:extLst>
            </p:cNvPr>
            <p:cNvGraphicFramePr/>
            <p:nvPr/>
          </p:nvGraphicFramePr>
          <p:xfrm>
            <a:off x="488" y="165"/>
            <a:ext cx="10769" cy="60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3" imgW="7109460" imgH="4206240" progId="Paint.Picture">
                    <p:embed/>
                  </p:oleObj>
                </mc:Choice>
                <mc:Fallback>
                  <p:oleObj r:id="rId3" imgW="7109460" imgH="4206240" progId="Paint.Picture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BC1A0F62-7271-A868-F2B7-4B39348F897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rcRect l="3891" t="3062" b="5122"/>
                        <a:stretch>
                          <a:fillRect/>
                        </a:stretch>
                      </p:blipFill>
                      <p:spPr>
                        <a:xfrm>
                          <a:off x="488" y="165"/>
                          <a:ext cx="10769" cy="60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" name="Text Box 5">
              <a:extLst>
                <a:ext uri="{FF2B5EF4-FFF2-40B4-BE49-F238E27FC236}">
                  <a16:creationId xmlns:a16="http://schemas.microsoft.com/office/drawing/2014/main" id="{41EBF81E-3A70-0673-3668-A0C4B631579C}"/>
                </a:ext>
              </a:extLst>
            </p:cNvPr>
            <p:cNvSpPr txBox="1"/>
            <p:nvPr/>
          </p:nvSpPr>
          <p:spPr>
            <a:xfrm>
              <a:off x="332" y="1195"/>
              <a:ext cx="1315" cy="6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altLang="en-US" u="sng"/>
                <a:t>KDa</a:t>
              </a:r>
            </a:p>
          </p:txBody>
        </p:sp>
        <p:sp>
          <p:nvSpPr>
            <p:cNvPr id="7" name="Text Box 8">
              <a:extLst>
                <a:ext uri="{FF2B5EF4-FFF2-40B4-BE49-F238E27FC236}">
                  <a16:creationId xmlns:a16="http://schemas.microsoft.com/office/drawing/2014/main" id="{2F926FF9-C433-1BA6-111D-AFE7B7C65942}"/>
                </a:ext>
              </a:extLst>
            </p:cNvPr>
            <p:cNvSpPr txBox="1"/>
            <p:nvPr/>
          </p:nvSpPr>
          <p:spPr>
            <a:xfrm>
              <a:off x="6781" y="1195"/>
              <a:ext cx="1315" cy="6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altLang="en-US" u="sng"/>
                <a:t>KDa</a:t>
              </a:r>
            </a:p>
          </p:txBody>
        </p:sp>
      </p:grpSp>
      <p:sp>
        <p:nvSpPr>
          <p:cNvPr id="8" name="Text Box 11">
            <a:extLst>
              <a:ext uri="{FF2B5EF4-FFF2-40B4-BE49-F238E27FC236}">
                <a16:creationId xmlns:a16="http://schemas.microsoft.com/office/drawing/2014/main" id="{8A2D6E2F-60E2-F912-05E8-334594ABE332}"/>
              </a:ext>
            </a:extLst>
          </p:cNvPr>
          <p:cNvSpPr txBox="1"/>
          <p:nvPr/>
        </p:nvSpPr>
        <p:spPr>
          <a:xfrm>
            <a:off x="2917457" y="5682345"/>
            <a:ext cx="259604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en-US" sz="1100" dirty="0"/>
              <a:t>Anti beta actin primary - 1 in 10000.</a:t>
            </a:r>
          </a:p>
          <a:p>
            <a:r>
              <a:rPr lang="en-GB" altLang="en-US" sz="1100" dirty="0"/>
              <a:t>Anti mouse green secondary - 1 in 2000</a:t>
            </a:r>
          </a:p>
        </p:txBody>
      </p:sp>
      <p:sp>
        <p:nvSpPr>
          <p:cNvPr id="9" name="Text Box 14">
            <a:extLst>
              <a:ext uri="{FF2B5EF4-FFF2-40B4-BE49-F238E27FC236}">
                <a16:creationId xmlns:a16="http://schemas.microsoft.com/office/drawing/2014/main" id="{E7F11C5D-558A-B9DD-20C6-23B2F802A1F6}"/>
              </a:ext>
            </a:extLst>
          </p:cNvPr>
          <p:cNvSpPr txBox="1"/>
          <p:nvPr/>
        </p:nvSpPr>
        <p:spPr>
          <a:xfrm>
            <a:off x="2934138" y="9234861"/>
            <a:ext cx="259604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en-US" sz="1100" dirty="0"/>
              <a:t>Anti PRH  primary - 1 in 500.</a:t>
            </a:r>
          </a:p>
          <a:p>
            <a:r>
              <a:rPr lang="en-GB" altLang="en-US" sz="1100" dirty="0"/>
              <a:t>Anti Rabbit HRP secondary - 1 in 2000</a:t>
            </a:r>
          </a:p>
        </p:txBody>
      </p:sp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76306708-B74C-1718-D078-B74BB5C3315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26993834"/>
              </p:ext>
            </p:extLst>
          </p:nvPr>
        </p:nvGraphicFramePr>
        <p:xfrm>
          <a:off x="552699" y="6615565"/>
          <a:ext cx="4977484" cy="24038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5" imgW="7833360" imgH="3870960" progId="Paint.Picture">
                  <p:embed/>
                </p:oleObj>
              </mc:Choice>
              <mc:Fallback>
                <p:oleObj r:id="rId5" imgW="7833360" imgH="3870960" progId="Paint.Picture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76306708-B74C-1718-D078-B74BB5C3315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rcRect t="2259"/>
                      <a:stretch>
                        <a:fillRect/>
                      </a:stretch>
                    </p:blipFill>
                    <p:spPr>
                      <a:xfrm>
                        <a:off x="552699" y="6615565"/>
                        <a:ext cx="4977484" cy="24038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97734250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le 1">
            <a:extLst>
              <a:ext uri="{FF2B5EF4-FFF2-40B4-BE49-F238E27FC236}">
                <a16:creationId xmlns:a16="http://schemas.microsoft.com/office/drawing/2014/main" id="{68A70B02-7EB9-0661-02E3-D7FEEE1A33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38681" y="-97218"/>
            <a:ext cx="5915025" cy="1193819"/>
          </a:xfrm>
        </p:spPr>
        <p:txBody>
          <a:bodyPr>
            <a:normAutofit/>
          </a:bodyPr>
          <a:lstStyle/>
          <a:p>
            <a:pPr>
              <a:lnSpc>
                <a:spcPct val="100000"/>
              </a:lnSpc>
            </a:pPr>
            <a:r>
              <a:rPr lang="en-GB" sz="1100" b="1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19  Niclosamide and </a:t>
            </a:r>
            <a:r>
              <a:rPr lang="en-GB" sz="1100" b="1" kern="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blociclib</a:t>
            </a:r>
            <a:r>
              <a:rPr lang="en-GB" sz="1100" b="1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ct synergistically to reduce the viability of RBE and KKU-M055 cells.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932259" y="849170"/>
            <a:ext cx="2311378" cy="1892215"/>
            <a:chOff x="4229403" y="7411553"/>
            <a:chExt cx="2311378" cy="1892215"/>
          </a:xfrm>
        </p:grpSpPr>
        <p:pic>
          <p:nvPicPr>
            <p:cNvPr id="46" name="Picture 45" descr="A close-up of a white rectangular object&#10;&#10;Description automatically generated">
              <a:extLst>
                <a:ext uri="{FF2B5EF4-FFF2-40B4-BE49-F238E27FC236}">
                  <a16:creationId xmlns:a16="http://schemas.microsoft.com/office/drawing/2014/main" id="{EE68DD3F-A12B-CBF3-F8E7-053FD30AC7C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756" t="22880" r="39476" b="68357"/>
            <a:stretch/>
          </p:blipFill>
          <p:spPr>
            <a:xfrm>
              <a:off x="4298980" y="8885340"/>
              <a:ext cx="1271754" cy="41744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8" name="Picture 47" descr="A black and white photo of a rectangular object&#10;&#10;Description automatically generated">
              <a:extLst>
                <a:ext uri="{FF2B5EF4-FFF2-40B4-BE49-F238E27FC236}">
                  <a16:creationId xmlns:a16="http://schemas.microsoft.com/office/drawing/2014/main" id="{6EAD21DB-D5D1-3A16-F116-572823AD6DD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665" t="20117" r="42493" b="72508"/>
            <a:stretch/>
          </p:blipFill>
          <p:spPr>
            <a:xfrm>
              <a:off x="4298980" y="8426166"/>
              <a:ext cx="1271754" cy="41588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4" name="Picture 53" descr="A close-up of a dna test&#10;&#10;Description automatically generated">
              <a:extLst>
                <a:ext uri="{FF2B5EF4-FFF2-40B4-BE49-F238E27FC236}">
                  <a16:creationId xmlns:a16="http://schemas.microsoft.com/office/drawing/2014/main" id="{C2B6F5C7-0326-B804-7CF4-0BEC79644D9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565" t="24838" r="38877" b="63218"/>
            <a:stretch/>
          </p:blipFill>
          <p:spPr>
            <a:xfrm>
              <a:off x="4298980" y="7967465"/>
              <a:ext cx="1267245" cy="41356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154" name="Group 153"/>
            <p:cNvGrpSpPr/>
            <p:nvPr/>
          </p:nvGrpSpPr>
          <p:grpSpPr>
            <a:xfrm>
              <a:off x="4229403" y="7411553"/>
              <a:ext cx="2311378" cy="1892215"/>
              <a:chOff x="547856" y="4659538"/>
              <a:chExt cx="2311378" cy="1892215"/>
            </a:xfrm>
          </p:grpSpPr>
          <p:sp>
            <p:nvSpPr>
              <p:cNvPr id="155" name="TextBox 7">
                <a:extLst>
                  <a:ext uri="{FF2B5EF4-FFF2-40B4-BE49-F238E27FC236}">
                    <a16:creationId xmlns:a16="http://schemas.microsoft.com/office/drawing/2014/main" id="{08F5A6E2-D785-E3AB-A979-E9041B5AC87C}"/>
                  </a:ext>
                </a:extLst>
              </p:cNvPr>
              <p:cNvSpPr txBox="1"/>
              <p:nvPr/>
            </p:nvSpPr>
            <p:spPr>
              <a:xfrm>
                <a:off x="547856" y="4918865"/>
                <a:ext cx="176221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900" dirty="0"/>
                  <a:t>    </a:t>
                </a:r>
                <a:r>
                  <a:rPr lang="en-GB" sz="800" dirty="0"/>
                  <a:t>VC    NIC     PAL   COM</a:t>
                </a:r>
              </a:p>
            </p:txBody>
          </p:sp>
          <p:sp>
            <p:nvSpPr>
              <p:cNvPr id="156" name="TextBox 155">
                <a:extLst>
                  <a:ext uri="{FF2B5EF4-FFF2-40B4-BE49-F238E27FC236}">
                    <a16:creationId xmlns:a16="http://schemas.microsoft.com/office/drawing/2014/main" id="{ABC9E646-3449-EEB7-C1A5-577738F33067}"/>
                  </a:ext>
                </a:extLst>
              </p:cNvPr>
              <p:cNvSpPr txBox="1"/>
              <p:nvPr/>
            </p:nvSpPr>
            <p:spPr>
              <a:xfrm>
                <a:off x="1831405" y="6182421"/>
                <a:ext cx="59824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GB" sz="900" dirty="0">
                    <a:latin typeface="Symbol" panose="05050102010706020507" pitchFamily="18" charset="2"/>
                    <a:cs typeface="Arial" panose="020B0604020202020204" pitchFamily="34" charset="0"/>
                  </a:rPr>
                  <a:t> b</a:t>
                </a:r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</a:p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42kDa</a:t>
                </a:r>
              </a:p>
            </p:txBody>
          </p:sp>
          <p:sp>
            <p:nvSpPr>
              <p:cNvPr id="157" name="TextBox 156">
                <a:extLst>
                  <a:ext uri="{FF2B5EF4-FFF2-40B4-BE49-F238E27FC236}">
                    <a16:creationId xmlns:a16="http://schemas.microsoft.com/office/drawing/2014/main" id="{D1A03DFF-84E0-CCAB-7BB2-54ECC456E63B}"/>
                  </a:ext>
                </a:extLst>
              </p:cNvPr>
              <p:cNvSpPr txBox="1"/>
              <p:nvPr/>
            </p:nvSpPr>
            <p:spPr>
              <a:xfrm>
                <a:off x="1831405" y="5708598"/>
                <a:ext cx="87075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 PRH</a:t>
                </a:r>
              </a:p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36kDa </a:t>
                </a:r>
              </a:p>
            </p:txBody>
          </p:sp>
          <p:sp>
            <p:nvSpPr>
              <p:cNvPr id="158" name="TextBox 157">
                <a:extLst>
                  <a:ext uri="{FF2B5EF4-FFF2-40B4-BE49-F238E27FC236}">
                    <a16:creationId xmlns:a16="http://schemas.microsoft.com/office/drawing/2014/main" id="{47AC1123-B605-B8B2-B5C5-36BD5069BD58}"/>
                  </a:ext>
                </a:extLst>
              </p:cNvPr>
              <p:cNvSpPr txBox="1"/>
              <p:nvPr/>
            </p:nvSpPr>
            <p:spPr>
              <a:xfrm>
                <a:off x="821150" y="4659538"/>
                <a:ext cx="101181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KKU-M055 cells</a:t>
                </a:r>
              </a:p>
            </p:txBody>
          </p:sp>
          <p:sp>
            <p:nvSpPr>
              <p:cNvPr id="159" name="TextBox 158">
                <a:extLst>
                  <a:ext uri="{FF2B5EF4-FFF2-40B4-BE49-F238E27FC236}">
                    <a16:creationId xmlns:a16="http://schemas.microsoft.com/office/drawing/2014/main" id="{55ACFD59-6976-CB60-5FAF-B5F1621A84F9}"/>
                  </a:ext>
                </a:extLst>
              </p:cNvPr>
              <p:cNvSpPr txBox="1"/>
              <p:nvPr/>
            </p:nvSpPr>
            <p:spPr>
              <a:xfrm>
                <a:off x="1831405" y="5249188"/>
                <a:ext cx="102782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 </a:t>
                </a:r>
                <a:r>
                  <a:rPr lang="en-GB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RB</a:t>
                </a:r>
                <a:endParaRPr lang="en-GB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10kDa</a:t>
                </a:r>
              </a:p>
            </p:txBody>
          </p:sp>
          <p:sp>
            <p:nvSpPr>
              <p:cNvPr id="160" name="Right Bracket 159">
                <a:extLst>
                  <a:ext uri="{FF2B5EF4-FFF2-40B4-BE49-F238E27FC236}">
                    <a16:creationId xmlns:a16="http://schemas.microsoft.com/office/drawing/2014/main" id="{F6F33509-2CA4-1FDC-E64B-A44D72331D05}"/>
                  </a:ext>
                </a:extLst>
              </p:cNvPr>
              <p:cNvSpPr/>
              <p:nvPr/>
            </p:nvSpPr>
            <p:spPr>
              <a:xfrm rot="16200000">
                <a:off x="1279592" y="4351645"/>
                <a:ext cx="45719" cy="1157229"/>
              </a:xfrm>
              <a:prstGeom prst="rightBracket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</p:grpSp>
      <p:grpSp>
        <p:nvGrpSpPr>
          <p:cNvPr id="161" name="Group 160"/>
          <p:cNvGrpSpPr/>
          <p:nvPr/>
        </p:nvGrpSpPr>
        <p:grpSpPr>
          <a:xfrm>
            <a:off x="4188166" y="849170"/>
            <a:ext cx="1377135" cy="1505212"/>
            <a:chOff x="4021377" y="896988"/>
            <a:chExt cx="1841541" cy="1870284"/>
          </a:xfrm>
        </p:grpSpPr>
        <p:sp>
          <p:nvSpPr>
            <p:cNvPr id="163" name="Rectangle 162"/>
            <p:cNvSpPr/>
            <p:nvPr/>
          </p:nvSpPr>
          <p:spPr>
            <a:xfrm>
              <a:off x="4244842" y="896988"/>
              <a:ext cx="1618076" cy="77944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65" name="Rectangle 164"/>
            <p:cNvSpPr/>
            <p:nvPr/>
          </p:nvSpPr>
          <p:spPr>
            <a:xfrm>
              <a:off x="4021377" y="2331065"/>
              <a:ext cx="223465" cy="43620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188" name="TextBox 187"/>
          <p:cNvSpPr txBox="1"/>
          <p:nvPr/>
        </p:nvSpPr>
        <p:spPr>
          <a:xfrm>
            <a:off x="660829" y="726059"/>
            <a:ext cx="5362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91180"/>
            <a:r>
              <a:rPr lang="en-GB" sz="1000" b="1" dirty="0">
                <a:solidFill>
                  <a:prstClr val="black"/>
                </a:solidFill>
                <a:latin typeface="Calibri"/>
              </a:rPr>
              <a:t>F  </a:t>
            </a:r>
          </a:p>
        </p:txBody>
      </p:sp>
      <p:pic>
        <p:nvPicPr>
          <p:cNvPr id="30" name="Picture 29" descr="A close-up of a dna test&#10;&#10;Description automatically generated">
            <a:extLst>
              <a:ext uri="{FF2B5EF4-FFF2-40B4-BE49-F238E27FC236}">
                <a16:creationId xmlns:a16="http://schemas.microsoft.com/office/drawing/2014/main" id="{C2B6F5C7-0326-B804-7CF4-0BEC79644D92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45" t="15583" r="5907" b="38202"/>
          <a:stretch/>
        </p:blipFill>
        <p:spPr>
          <a:xfrm>
            <a:off x="560440" y="2881235"/>
            <a:ext cx="5936224" cy="1600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Picture 30" descr="A black and white photo of a rectangular object&#10;&#10;Description automatically generated">
            <a:extLst>
              <a:ext uri="{FF2B5EF4-FFF2-40B4-BE49-F238E27FC236}">
                <a16:creationId xmlns:a16="http://schemas.microsoft.com/office/drawing/2014/main" id="{6EAD21DB-D5D1-3A16-F116-572823AD6DD0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05" t="12314" r="5926" b="49895"/>
          <a:stretch/>
        </p:blipFill>
        <p:spPr>
          <a:xfrm>
            <a:off x="586412" y="4686230"/>
            <a:ext cx="5692877" cy="213114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4" name="Picture 33" descr="A close-up of a white rectangular object&#10;&#10;Description automatically generated">
            <a:extLst>
              <a:ext uri="{FF2B5EF4-FFF2-40B4-BE49-F238E27FC236}">
                <a16:creationId xmlns:a16="http://schemas.microsoft.com/office/drawing/2014/main" id="{EE68DD3F-A12B-CBF3-F8E7-053FD30AC7C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134" t="13641" r="-2841" b="51837"/>
          <a:stretch/>
        </p:blipFill>
        <p:spPr>
          <a:xfrm>
            <a:off x="353962" y="7022167"/>
            <a:ext cx="6349180" cy="1644446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1654278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Title 1">
            <a:extLst>
              <a:ext uri="{FF2B5EF4-FFF2-40B4-BE49-F238E27FC236}">
                <a16:creationId xmlns:a16="http://schemas.microsoft.com/office/drawing/2014/main" id="{68A70B02-7EB9-0661-02E3-D7FEEE1A3328}"/>
              </a:ext>
            </a:extLst>
          </p:cNvPr>
          <p:cNvSpPr txBox="1">
            <a:spLocks/>
          </p:cNvSpPr>
          <p:nvPr/>
        </p:nvSpPr>
        <p:spPr>
          <a:xfrm>
            <a:off x="207882" y="456394"/>
            <a:ext cx="6162385" cy="31033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100" b="1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14  Niclosamide decreases the levels of multiple proteins that determine CCA cell viability.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9" name="Picture 38" descr="A screenshot of a computer&#10;&#10;Description automatically generated">
            <a:extLst>
              <a:ext uri="{FF2B5EF4-FFF2-40B4-BE49-F238E27FC236}">
                <a16:creationId xmlns:a16="http://schemas.microsoft.com/office/drawing/2014/main" id="{E78FCAF3-4661-C90C-9F5C-BC598F77422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444" t="52963" r="20417" b="39959"/>
          <a:stretch/>
        </p:blipFill>
        <p:spPr>
          <a:xfrm>
            <a:off x="359179" y="2693483"/>
            <a:ext cx="1498459" cy="27403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ABC9E646-3449-EEB7-C1A5-577738F33067}"/>
              </a:ext>
            </a:extLst>
          </p:cNvPr>
          <p:cNvSpPr txBox="1"/>
          <p:nvPr/>
        </p:nvSpPr>
        <p:spPr>
          <a:xfrm>
            <a:off x="1802765" y="2692570"/>
            <a:ext cx="5982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GB" sz="900" dirty="0">
                <a:latin typeface="Symbol" panose="05050102010706020507" pitchFamily="18" charset="2"/>
                <a:cs typeface="Arial" panose="020B0604020202020204" pitchFamily="34" charset="0"/>
              </a:rPr>
              <a:t> b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2kDa</a:t>
            </a:r>
          </a:p>
        </p:txBody>
      </p:sp>
      <p:pic>
        <p:nvPicPr>
          <p:cNvPr id="45" name="Picture 44" descr="A close-up of a black and white image&#10;&#10;Description automatically generated">
            <a:extLst>
              <a:ext uri="{FF2B5EF4-FFF2-40B4-BE49-F238E27FC236}">
                <a16:creationId xmlns:a16="http://schemas.microsoft.com/office/drawing/2014/main" id="{C972208C-B908-66F0-E50C-94D6E6984B59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725" t="29893" r="21893" b="58943"/>
          <a:stretch/>
        </p:blipFill>
        <p:spPr>
          <a:xfrm>
            <a:off x="359179" y="3429169"/>
            <a:ext cx="1501419" cy="44473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3B452009-EA2E-B7AE-9D8B-0D61DBC7AB0A}"/>
              </a:ext>
            </a:extLst>
          </p:cNvPr>
          <p:cNvSpPr txBox="1"/>
          <p:nvPr/>
        </p:nvSpPr>
        <p:spPr>
          <a:xfrm>
            <a:off x="1802765" y="3549425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 Cleaved Casp3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7kDa</a:t>
            </a:r>
          </a:p>
        </p:txBody>
      </p:sp>
      <p:pic>
        <p:nvPicPr>
          <p:cNvPr id="30" name="Content Placeholder 5" descr="A close-up of a test&#10;&#10;Description automatically generated">
            <a:extLst>
              <a:ext uri="{FF2B5EF4-FFF2-40B4-BE49-F238E27FC236}">
                <a16:creationId xmlns:a16="http://schemas.microsoft.com/office/drawing/2014/main" id="{9FEBBD49-9302-C68D-6DBD-8B0D10480A51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867" t="44580" r="22030" b="46965"/>
          <a:stretch/>
        </p:blipFill>
        <p:spPr>
          <a:xfrm>
            <a:off x="359179" y="3912781"/>
            <a:ext cx="1501419" cy="33931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87790B87-54D1-E084-BA95-873AFF08CC4D}"/>
              </a:ext>
            </a:extLst>
          </p:cNvPr>
          <p:cNvSpPr txBox="1"/>
          <p:nvPr/>
        </p:nvSpPr>
        <p:spPr>
          <a:xfrm>
            <a:off x="1802765" y="3104903"/>
            <a:ext cx="748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 Cyclin D1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C8EDE08-F0BA-DDF4-8211-8FE6C1419AFB}"/>
              </a:ext>
            </a:extLst>
          </p:cNvPr>
          <p:cNvSpPr txBox="1"/>
          <p:nvPr/>
        </p:nvSpPr>
        <p:spPr>
          <a:xfrm>
            <a:off x="1802765" y="3946717"/>
            <a:ext cx="5982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GB" sz="900" dirty="0">
                <a:latin typeface="Symbol" panose="05050102010706020507" pitchFamily="18" charset="2"/>
                <a:cs typeface="Arial" panose="020B0604020202020204" pitchFamily="34" charset="0"/>
              </a:rPr>
              <a:t> b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2kDa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D1A03DFF-84E0-CCAB-7BB2-54ECC456E63B}"/>
              </a:ext>
            </a:extLst>
          </p:cNvPr>
          <p:cNvSpPr txBox="1"/>
          <p:nvPr/>
        </p:nvSpPr>
        <p:spPr>
          <a:xfrm>
            <a:off x="1802765" y="2305981"/>
            <a:ext cx="8707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GB" sz="9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catenin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0kDa 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3ACED952-5CC4-386F-53CD-BF4679B73590}"/>
              </a:ext>
            </a:extLst>
          </p:cNvPr>
          <p:cNvSpPr txBox="1"/>
          <p:nvPr/>
        </p:nvSpPr>
        <p:spPr>
          <a:xfrm>
            <a:off x="287220" y="1568600"/>
            <a:ext cx="16257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VC    1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M    2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M    4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M    8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M 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47AC1123-B605-B8B2-B5C5-36BD5069BD58}"/>
              </a:ext>
            </a:extLst>
          </p:cNvPr>
          <p:cNvSpPr txBox="1"/>
          <p:nvPr/>
        </p:nvSpPr>
        <p:spPr>
          <a:xfrm>
            <a:off x="797535" y="1335746"/>
            <a:ext cx="7441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iclosamide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Right Bracket 77">
            <a:extLst>
              <a:ext uri="{FF2B5EF4-FFF2-40B4-BE49-F238E27FC236}">
                <a16:creationId xmlns:a16="http://schemas.microsoft.com/office/drawing/2014/main" id="{6B369DAA-6B16-DCDD-2302-430D7C7C7DE4}"/>
              </a:ext>
            </a:extLst>
          </p:cNvPr>
          <p:cNvSpPr/>
          <p:nvPr/>
        </p:nvSpPr>
        <p:spPr>
          <a:xfrm rot="16200000">
            <a:off x="1180916" y="979712"/>
            <a:ext cx="45719" cy="1157229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69" name="Picture 68" descr="A close up of a black and white photo&#10;&#10;Description automatically generated">
            <a:extLst>
              <a:ext uri="{FF2B5EF4-FFF2-40B4-BE49-F238E27FC236}">
                <a16:creationId xmlns:a16="http://schemas.microsoft.com/office/drawing/2014/main" id="{724E4D66-1722-A13F-C071-E1961D6DE4A3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846" t="36678" r="43374" b="53155"/>
          <a:stretch/>
        </p:blipFill>
        <p:spPr>
          <a:xfrm>
            <a:off x="359179" y="1783827"/>
            <a:ext cx="1492405" cy="41697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1" name="TextBox 70">
            <a:extLst>
              <a:ext uri="{FF2B5EF4-FFF2-40B4-BE49-F238E27FC236}">
                <a16:creationId xmlns:a16="http://schemas.microsoft.com/office/drawing/2014/main" id="{55ACFD59-6976-CB60-5FAF-B5F1621A84F9}"/>
              </a:ext>
            </a:extLst>
          </p:cNvPr>
          <p:cNvSpPr txBox="1"/>
          <p:nvPr/>
        </p:nvSpPr>
        <p:spPr>
          <a:xfrm>
            <a:off x="1802765" y="1839675"/>
            <a:ext cx="10278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 PRH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</a:p>
        </p:txBody>
      </p:sp>
      <p:pic>
        <p:nvPicPr>
          <p:cNvPr id="72" name="Picture 71" descr="A screenshot of a computer&#10;&#10;Description automatically generated">
            <a:extLst>
              <a:ext uri="{FF2B5EF4-FFF2-40B4-BE49-F238E27FC236}">
                <a16:creationId xmlns:a16="http://schemas.microsoft.com/office/drawing/2014/main" id="{5D3008CD-94C2-9EDD-A372-5CDC2E0A433F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146" t="44011" r="3722" b="22078"/>
          <a:stretch/>
        </p:blipFill>
        <p:spPr>
          <a:xfrm>
            <a:off x="359179" y="2245648"/>
            <a:ext cx="1496578" cy="406311"/>
          </a:xfrm>
          <a:prstGeom prst="rect">
            <a:avLst/>
          </a:prstGeom>
          <a:solidFill>
            <a:schemeClr val="tx1"/>
          </a:solidFill>
          <a:ln>
            <a:solidFill>
              <a:schemeClr val="tx2"/>
            </a:solidFill>
          </a:ln>
        </p:spPr>
      </p:pic>
      <p:sp>
        <p:nvSpPr>
          <p:cNvPr id="81" name="TextBox 80"/>
          <p:cNvSpPr txBox="1"/>
          <p:nvPr/>
        </p:nvSpPr>
        <p:spPr>
          <a:xfrm>
            <a:off x="207882" y="1034976"/>
            <a:ext cx="5362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91180"/>
            <a:r>
              <a:rPr lang="en-GB" sz="1000" b="1" dirty="0">
                <a:solidFill>
                  <a:prstClr val="black"/>
                </a:solidFill>
                <a:latin typeface="Calibri"/>
              </a:rPr>
              <a:t>A   </a:t>
            </a:r>
          </a:p>
        </p:txBody>
      </p:sp>
      <p:pic>
        <p:nvPicPr>
          <p:cNvPr id="2" name="Content Placeholder 7" descr="A white rectangular object with black lines&#10;&#10;Description automatically generated">
            <a:extLst>
              <a:ext uri="{FF2B5EF4-FFF2-40B4-BE49-F238E27FC236}">
                <a16:creationId xmlns:a16="http://schemas.microsoft.com/office/drawing/2014/main" id="{51044E52-0375-7A89-380E-85AD4AE8E3F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985" t="55518" r="20339" b="34446"/>
          <a:stretch/>
        </p:blipFill>
        <p:spPr>
          <a:xfrm>
            <a:off x="353431" y="3026208"/>
            <a:ext cx="1507167" cy="349811"/>
          </a:xfrm>
          <a:ln>
            <a:solidFill>
              <a:schemeClr val="tx2"/>
            </a:solidFill>
          </a:ln>
        </p:spPr>
      </p:pic>
      <p:pic>
        <p:nvPicPr>
          <p:cNvPr id="112" name="Picture 111" descr="A close up of a black and white photo&#10;&#10;Description automatically generated">
            <a:extLst>
              <a:ext uri="{FF2B5EF4-FFF2-40B4-BE49-F238E27FC236}">
                <a16:creationId xmlns:a16="http://schemas.microsoft.com/office/drawing/2014/main" id="{724E4D66-1722-A13F-C071-E1961D6DE4A3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188" t="27875" r="17946" b="37270"/>
          <a:stretch/>
        </p:blipFill>
        <p:spPr>
          <a:xfrm>
            <a:off x="3281447" y="922025"/>
            <a:ext cx="2250027" cy="97750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8" name="Picture 127" descr="A screenshot of a computer&#10;&#10;Description automatically generated">
            <a:extLst>
              <a:ext uri="{FF2B5EF4-FFF2-40B4-BE49-F238E27FC236}">
                <a16:creationId xmlns:a16="http://schemas.microsoft.com/office/drawing/2014/main" id="{E78FCAF3-4661-C90C-9F5C-BC598F77422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444" t="45425" r="20417" b="33453"/>
          <a:stretch/>
        </p:blipFill>
        <p:spPr>
          <a:xfrm>
            <a:off x="3657230" y="2138533"/>
            <a:ext cx="1498459" cy="81780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1" name="Content Placeholder 7" descr="A white rectangular object with black lines&#10;&#10;Description automatically generated">
            <a:extLst>
              <a:ext uri="{FF2B5EF4-FFF2-40B4-BE49-F238E27FC236}">
                <a16:creationId xmlns:a16="http://schemas.microsoft.com/office/drawing/2014/main" id="{51044E52-0375-7A89-380E-85AD4AE8E3FD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865" t="29576" r="15359" b="25347"/>
          <a:stretch/>
        </p:blipFill>
        <p:spPr>
          <a:xfrm>
            <a:off x="3490173" y="3324924"/>
            <a:ext cx="2041301" cy="1571222"/>
          </a:xfrm>
          <a:prstGeom prst="rect">
            <a:avLst/>
          </a:prstGeom>
          <a:ln>
            <a:solidFill>
              <a:schemeClr val="tx2"/>
            </a:solidFill>
          </a:ln>
        </p:spPr>
      </p:pic>
      <p:pic>
        <p:nvPicPr>
          <p:cNvPr id="132" name="Picture 131" descr="A close-up of a black and white image&#10;&#10;Description automatically generated">
            <a:extLst>
              <a:ext uri="{FF2B5EF4-FFF2-40B4-BE49-F238E27FC236}">
                <a16:creationId xmlns:a16="http://schemas.microsoft.com/office/drawing/2014/main" id="{C972208C-B908-66F0-E50C-94D6E6984B59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66" t="11089" r="19645" b="48499"/>
          <a:stretch/>
        </p:blipFill>
        <p:spPr>
          <a:xfrm>
            <a:off x="1407921" y="5540194"/>
            <a:ext cx="3941012" cy="14793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7" name="Content Placeholder 5" descr="A close-up of a test&#10;&#10;Description automatically generated">
            <a:extLst>
              <a:ext uri="{FF2B5EF4-FFF2-40B4-BE49-F238E27FC236}">
                <a16:creationId xmlns:a16="http://schemas.microsoft.com/office/drawing/2014/main" id="{9FEBBD49-9302-C68D-6DBD-8B0D10480A51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693" t="22442" r="22031" b="35678"/>
          <a:stretch/>
        </p:blipFill>
        <p:spPr>
          <a:xfrm>
            <a:off x="1407921" y="7464076"/>
            <a:ext cx="4006774" cy="1748163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1356001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Title 1">
            <a:extLst>
              <a:ext uri="{FF2B5EF4-FFF2-40B4-BE49-F238E27FC236}">
                <a16:creationId xmlns:a16="http://schemas.microsoft.com/office/drawing/2014/main" id="{68A70B02-7EB9-0661-02E3-D7FEEE1A3328}"/>
              </a:ext>
            </a:extLst>
          </p:cNvPr>
          <p:cNvSpPr txBox="1">
            <a:spLocks/>
          </p:cNvSpPr>
          <p:nvPr/>
        </p:nvSpPr>
        <p:spPr>
          <a:xfrm>
            <a:off x="207882" y="456394"/>
            <a:ext cx="6162385" cy="31033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100" b="1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14  Niclosamide decreases the levels of multiple proteins that determine CCA cell viability.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473247" y="1895266"/>
            <a:ext cx="5362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91180"/>
            <a:r>
              <a:rPr lang="en-GB" sz="1000" b="1" dirty="0">
                <a:solidFill>
                  <a:prstClr val="black"/>
                </a:solidFill>
                <a:latin typeface="Calibri"/>
              </a:rPr>
              <a:t>B   </a:t>
            </a:r>
          </a:p>
        </p:txBody>
      </p:sp>
      <p:grpSp>
        <p:nvGrpSpPr>
          <p:cNvPr id="129" name="Group 128"/>
          <p:cNvGrpSpPr/>
          <p:nvPr/>
        </p:nvGrpSpPr>
        <p:grpSpPr>
          <a:xfrm>
            <a:off x="744178" y="2372192"/>
            <a:ext cx="2290082" cy="1886937"/>
            <a:chOff x="2634035" y="1140215"/>
            <a:chExt cx="2290082" cy="1886937"/>
          </a:xfrm>
        </p:grpSpPr>
        <p:pic>
          <p:nvPicPr>
            <p:cNvPr id="93" name="Picture 92">
              <a:extLst>
                <a:ext uri="{FF2B5EF4-FFF2-40B4-BE49-F238E27FC236}">
                  <a16:creationId xmlns:a16="http://schemas.microsoft.com/office/drawing/2014/main" id="{0ECEFD04-14BA-DB2E-4254-013D218DBB3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35834" t="39483" r="26240" b="50074"/>
            <a:stretch/>
          </p:blipFill>
          <p:spPr>
            <a:xfrm>
              <a:off x="2642971" y="2580763"/>
              <a:ext cx="1526048" cy="35544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5784B4B1-6F31-0C8C-75F3-51EA1B7F9A58}"/>
                </a:ext>
              </a:extLst>
            </p:cNvPr>
            <p:cNvSpPr txBox="1"/>
            <p:nvPr/>
          </p:nvSpPr>
          <p:spPr>
            <a:xfrm>
              <a:off x="4114983" y="2627042"/>
              <a:ext cx="80913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/>
                <a:t>- </a:t>
              </a:r>
              <a:r>
                <a:rPr lang="en-GB" sz="900" dirty="0">
                  <a:latin typeface="Symbol" panose="05050102010706020507" pitchFamily="18" charset="2"/>
                </a:rPr>
                <a:t>b</a:t>
              </a:r>
              <a:r>
                <a:rPr lang="en-GB" sz="900" dirty="0"/>
                <a:t>-actin</a:t>
              </a:r>
            </a:p>
            <a:p>
              <a:r>
                <a:rPr lang="en-GB" sz="1100" dirty="0"/>
                <a:t>  </a:t>
              </a:r>
              <a:r>
                <a:rPr lang="en-GB" sz="900" dirty="0"/>
                <a:t>42kDa</a:t>
              </a:r>
            </a:p>
          </p:txBody>
        </p:sp>
        <p:grpSp>
          <p:nvGrpSpPr>
            <p:cNvPr id="32" name="Group 31"/>
            <p:cNvGrpSpPr/>
            <p:nvPr/>
          </p:nvGrpSpPr>
          <p:grpSpPr>
            <a:xfrm>
              <a:off x="2634035" y="1140215"/>
              <a:ext cx="2135652" cy="1475562"/>
              <a:chOff x="3059780" y="1418451"/>
              <a:chExt cx="2135652" cy="1475562"/>
            </a:xfrm>
          </p:grpSpPr>
          <p:pic>
            <p:nvPicPr>
              <p:cNvPr id="89" name="Picture 88">
                <a:extLst>
                  <a:ext uri="{FF2B5EF4-FFF2-40B4-BE49-F238E27FC236}">
                    <a16:creationId xmlns:a16="http://schemas.microsoft.com/office/drawing/2014/main" id="{924D1D83-A8D8-9863-32E9-E7999F0A753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40944" t="14302" r="20701" b="55325"/>
              <a:stretch/>
            </p:blipFill>
            <p:spPr>
              <a:xfrm>
                <a:off x="3068716" y="1806406"/>
                <a:ext cx="1526048" cy="101108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DEDC9519-1EA8-2FA9-BACF-286A582525BB}"/>
                  </a:ext>
                </a:extLst>
              </p:cNvPr>
              <p:cNvSpPr txBox="1"/>
              <p:nvPr/>
            </p:nvSpPr>
            <p:spPr>
              <a:xfrm>
                <a:off x="4539483" y="1739851"/>
                <a:ext cx="655949" cy="115416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/>
                  <a:t>- 250kDa</a:t>
                </a:r>
              </a:p>
              <a:p>
                <a:endParaRPr lang="en-GB" sz="900" dirty="0"/>
              </a:p>
              <a:p>
                <a:endParaRPr lang="en-GB" sz="900" dirty="0"/>
              </a:p>
              <a:p>
                <a:r>
                  <a:rPr lang="en-GB" sz="900" dirty="0"/>
                  <a:t>  </a:t>
                </a:r>
                <a:r>
                  <a:rPr lang="en-GB" sz="900" dirty="0" err="1"/>
                  <a:t>Ub</a:t>
                </a:r>
                <a:r>
                  <a:rPr lang="en-GB" sz="900" dirty="0"/>
                  <a:t> </a:t>
                </a:r>
              </a:p>
              <a:p>
                <a:r>
                  <a:rPr lang="en-GB" sz="900" dirty="0"/>
                  <a:t>  proteins</a:t>
                </a:r>
              </a:p>
              <a:p>
                <a:endParaRPr lang="en-GB" sz="600" dirty="0"/>
              </a:p>
              <a:p>
                <a:endParaRPr lang="en-GB" sz="900" dirty="0"/>
              </a:p>
              <a:p>
                <a:r>
                  <a:rPr lang="en-GB" sz="900" dirty="0"/>
                  <a:t>- 50kDa</a:t>
                </a:r>
              </a:p>
            </p:txBody>
          </p:sp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id="{37D09593-22A0-8034-96D3-999B79237BAC}"/>
                  </a:ext>
                </a:extLst>
              </p:cNvPr>
              <p:cNvSpPr txBox="1"/>
              <p:nvPr/>
            </p:nvSpPr>
            <p:spPr>
              <a:xfrm>
                <a:off x="3059780" y="1633641"/>
                <a:ext cx="55015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VC      NIC</a:t>
                </a:r>
              </a:p>
            </p:txBody>
          </p: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FC1593E4-609E-0DAB-8793-D811189CF22E}"/>
                  </a:ext>
                </a:extLst>
              </p:cNvPr>
              <p:cNvSpPr txBox="1"/>
              <p:nvPr/>
            </p:nvSpPr>
            <p:spPr>
              <a:xfrm>
                <a:off x="3529685" y="1633641"/>
                <a:ext cx="591829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VC      NIC </a:t>
                </a:r>
              </a:p>
            </p:txBody>
          </p: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D741BF5E-ECBA-2060-14B7-7DFF027473BE}"/>
                  </a:ext>
                </a:extLst>
              </p:cNvPr>
              <p:cNvSpPr txBox="1"/>
              <p:nvPr/>
            </p:nvSpPr>
            <p:spPr>
              <a:xfrm>
                <a:off x="4035334" y="1633641"/>
                <a:ext cx="55015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VC      NIC</a:t>
                </a:r>
              </a:p>
            </p:txBody>
          </p:sp>
          <p:sp>
            <p:nvSpPr>
              <p:cNvPr id="100" name="Right Bracket 99">
                <a:extLst>
                  <a:ext uri="{FF2B5EF4-FFF2-40B4-BE49-F238E27FC236}">
                    <a16:creationId xmlns:a16="http://schemas.microsoft.com/office/drawing/2014/main" id="{E9F55804-3D50-B77E-170B-B1E4FE169ACA}"/>
                  </a:ext>
                </a:extLst>
              </p:cNvPr>
              <p:cNvSpPr/>
              <p:nvPr/>
            </p:nvSpPr>
            <p:spPr>
              <a:xfrm rot="16200000">
                <a:off x="4274699" y="1464622"/>
                <a:ext cx="45719" cy="372418"/>
              </a:xfrm>
              <a:prstGeom prst="rightBracket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 sz="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4EC5BEAB-AB09-6509-B11E-0746BF62CE15}"/>
                  </a:ext>
                </a:extLst>
              </p:cNvPr>
              <p:cNvSpPr txBox="1"/>
              <p:nvPr/>
            </p:nvSpPr>
            <p:spPr>
              <a:xfrm>
                <a:off x="3107246" y="1418451"/>
                <a:ext cx="45878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CLP</a:t>
                </a:r>
              </a:p>
            </p:txBody>
          </p: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57EC3B92-3EBC-6C42-68DF-A7B97AC55108}"/>
                  </a:ext>
                </a:extLst>
              </p:cNvPr>
              <p:cNvSpPr txBox="1"/>
              <p:nvPr/>
            </p:nvSpPr>
            <p:spPr>
              <a:xfrm>
                <a:off x="3616999" y="1418451"/>
                <a:ext cx="3962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BE</a:t>
                </a:r>
              </a:p>
            </p:txBody>
          </p: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C1D764B5-9A24-EA42-9254-FF27C5FB1DE7}"/>
                  </a:ext>
                </a:extLst>
              </p:cNvPr>
              <p:cNvSpPr txBox="1"/>
              <p:nvPr/>
            </p:nvSpPr>
            <p:spPr>
              <a:xfrm>
                <a:off x="3981822" y="1418451"/>
                <a:ext cx="68800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KKU-M055</a:t>
                </a:r>
              </a:p>
            </p:txBody>
          </p:sp>
          <p:sp>
            <p:nvSpPr>
              <p:cNvPr id="104" name="Right Bracket 103">
                <a:extLst>
                  <a:ext uri="{FF2B5EF4-FFF2-40B4-BE49-F238E27FC236}">
                    <a16:creationId xmlns:a16="http://schemas.microsoft.com/office/drawing/2014/main" id="{EAFF9783-2DB7-160C-A26A-76CBB2E1D4B6}"/>
                  </a:ext>
                </a:extLst>
              </p:cNvPr>
              <p:cNvSpPr/>
              <p:nvPr/>
            </p:nvSpPr>
            <p:spPr>
              <a:xfrm rot="16200000">
                <a:off x="3792631" y="1462072"/>
                <a:ext cx="45719" cy="377518"/>
              </a:xfrm>
              <a:prstGeom prst="rightBracket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 sz="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" name="Right Bracket 104">
                <a:extLst>
                  <a:ext uri="{FF2B5EF4-FFF2-40B4-BE49-F238E27FC236}">
                    <a16:creationId xmlns:a16="http://schemas.microsoft.com/office/drawing/2014/main" id="{160B9579-B22E-6C51-8CCC-ABE2A34EF310}"/>
                  </a:ext>
                </a:extLst>
              </p:cNvPr>
              <p:cNvSpPr/>
              <p:nvPr/>
            </p:nvSpPr>
            <p:spPr>
              <a:xfrm rot="16200000">
                <a:off x="3302286" y="1464706"/>
                <a:ext cx="45719" cy="372251"/>
              </a:xfrm>
              <a:prstGeom prst="rightBracket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 sz="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pic>
        <p:nvPicPr>
          <p:cNvPr id="52" name="Picture 51">
            <a:extLst>
              <a:ext uri="{FF2B5EF4-FFF2-40B4-BE49-F238E27FC236}">
                <a16:creationId xmlns:a16="http://schemas.microsoft.com/office/drawing/2014/main" id="{924D1D83-A8D8-9863-32E9-E7999F0A753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8231" t="12481" r="13308" b="29099"/>
          <a:stretch/>
        </p:blipFill>
        <p:spPr>
          <a:xfrm>
            <a:off x="3387143" y="2372192"/>
            <a:ext cx="2723882" cy="194470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0ECEFD04-14BA-DB2E-4254-013D218DBB3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5630" t="26109" r="21635" b="34351"/>
          <a:stretch/>
        </p:blipFill>
        <p:spPr>
          <a:xfrm>
            <a:off x="3453450" y="4836217"/>
            <a:ext cx="2524259" cy="1345842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7918314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le 1">
            <a:extLst>
              <a:ext uri="{FF2B5EF4-FFF2-40B4-BE49-F238E27FC236}">
                <a16:creationId xmlns:a16="http://schemas.microsoft.com/office/drawing/2014/main" id="{68A70B02-7EB9-0661-02E3-D7FEEE1A33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05132" y="149623"/>
            <a:ext cx="5915025" cy="521065"/>
          </a:xfrm>
        </p:spPr>
        <p:txBody>
          <a:bodyPr>
            <a:normAutofit/>
          </a:bodyPr>
          <a:lstStyle/>
          <a:p>
            <a:r>
              <a:rPr lang="en-GB" sz="1100" b="1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15 Niclosamide and </a:t>
            </a:r>
            <a:r>
              <a:rPr lang="en-GB" sz="1100" b="1" kern="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blociclib</a:t>
            </a:r>
            <a:r>
              <a:rPr lang="en-GB" sz="1100" b="1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ct synergistically to reduce CCA cell viability.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2" name="Group 291"/>
          <p:cNvGrpSpPr/>
          <p:nvPr/>
        </p:nvGrpSpPr>
        <p:grpSpPr>
          <a:xfrm>
            <a:off x="283906" y="876332"/>
            <a:ext cx="2311378" cy="1798429"/>
            <a:chOff x="547856" y="4659538"/>
            <a:chExt cx="2311378" cy="1798429"/>
          </a:xfrm>
        </p:grpSpPr>
        <p:sp>
          <p:nvSpPr>
            <p:cNvPr id="26" name="TextBox 7">
              <a:extLst>
                <a:ext uri="{FF2B5EF4-FFF2-40B4-BE49-F238E27FC236}">
                  <a16:creationId xmlns:a16="http://schemas.microsoft.com/office/drawing/2014/main" id="{08F5A6E2-D785-E3AB-A979-E9041B5AC87C}"/>
                </a:ext>
              </a:extLst>
            </p:cNvPr>
            <p:cNvSpPr txBox="1"/>
            <p:nvPr/>
          </p:nvSpPr>
          <p:spPr>
            <a:xfrm>
              <a:off x="547856" y="4918865"/>
              <a:ext cx="176221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900" dirty="0"/>
                <a:t>    </a:t>
              </a:r>
              <a:r>
                <a:rPr lang="en-GB" sz="800" dirty="0"/>
                <a:t>VC    NIC     PAL   COM</a:t>
              </a:r>
            </a:p>
          </p:txBody>
        </p:sp>
        <p:pic>
          <p:nvPicPr>
            <p:cNvPr id="44" name="Picture 43" descr="A close-up of a test&#10;&#10;Description automatically generated">
              <a:extLst>
                <a:ext uri="{FF2B5EF4-FFF2-40B4-BE49-F238E27FC236}">
                  <a16:creationId xmlns:a16="http://schemas.microsoft.com/office/drawing/2014/main" id="{EAD973AB-9BBB-2FFC-1AF2-2149D374257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971" t="21916" r="42892" b="70536"/>
            <a:stretch/>
          </p:blipFill>
          <p:spPr>
            <a:xfrm>
              <a:off x="633614" y="6018544"/>
              <a:ext cx="1247649" cy="40953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8" name="Picture 47" descr="A black and white image of a rectangular object&#10;&#10;Description automatically generated">
              <a:extLst>
                <a:ext uri="{FF2B5EF4-FFF2-40B4-BE49-F238E27FC236}">
                  <a16:creationId xmlns:a16="http://schemas.microsoft.com/office/drawing/2014/main" id="{E7FEF639-11A8-1C8C-08FE-4B924D47CE0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827" t="20916" r="42218" b="71280"/>
            <a:stretch/>
          </p:blipFill>
          <p:spPr>
            <a:xfrm>
              <a:off x="633614" y="5577476"/>
              <a:ext cx="1247650" cy="39400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3" name="Picture 52" descr="A close-up of a test tube&#10;&#10;Description automatically generated">
              <a:extLst>
                <a:ext uri="{FF2B5EF4-FFF2-40B4-BE49-F238E27FC236}">
                  <a16:creationId xmlns:a16="http://schemas.microsoft.com/office/drawing/2014/main" id="{9B994843-C1AB-9F97-9EA5-A5932168978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685" t="24773" r="45362" b="65595"/>
            <a:stretch/>
          </p:blipFill>
          <p:spPr>
            <a:xfrm>
              <a:off x="633614" y="5130923"/>
              <a:ext cx="1247649" cy="39400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29" name="TextBox 328">
              <a:extLst>
                <a:ext uri="{FF2B5EF4-FFF2-40B4-BE49-F238E27FC236}">
                  <a16:creationId xmlns:a16="http://schemas.microsoft.com/office/drawing/2014/main" id="{ABC9E646-3449-EEB7-C1A5-577738F33067}"/>
                </a:ext>
              </a:extLst>
            </p:cNvPr>
            <p:cNvSpPr txBox="1"/>
            <p:nvPr/>
          </p:nvSpPr>
          <p:spPr>
            <a:xfrm>
              <a:off x="1831405" y="6088635"/>
              <a:ext cx="5982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GB" sz="900" dirty="0">
                  <a:latin typeface="Symbol" panose="05050102010706020507" pitchFamily="18" charset="2"/>
                  <a:cs typeface="Arial" panose="020B0604020202020204" pitchFamily="34" charset="0"/>
                </a:rPr>
                <a:t> b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42kDa</a:t>
              </a:r>
            </a:p>
          </p:txBody>
        </p:sp>
        <p:sp>
          <p:nvSpPr>
            <p:cNvPr id="330" name="TextBox 329">
              <a:extLst>
                <a:ext uri="{FF2B5EF4-FFF2-40B4-BE49-F238E27FC236}">
                  <a16:creationId xmlns:a16="http://schemas.microsoft.com/office/drawing/2014/main" id="{D1A03DFF-84E0-CCAB-7BB2-54ECC456E63B}"/>
                </a:ext>
              </a:extLst>
            </p:cNvPr>
            <p:cNvSpPr txBox="1"/>
            <p:nvPr/>
          </p:nvSpPr>
          <p:spPr>
            <a:xfrm>
              <a:off x="1831405" y="5661702"/>
              <a:ext cx="87075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 PRH</a:t>
              </a:r>
            </a:p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36kDa </a:t>
              </a:r>
            </a:p>
          </p:txBody>
        </p:sp>
        <p:sp>
          <p:nvSpPr>
            <p:cNvPr id="332" name="TextBox 331">
              <a:extLst>
                <a:ext uri="{FF2B5EF4-FFF2-40B4-BE49-F238E27FC236}">
                  <a16:creationId xmlns:a16="http://schemas.microsoft.com/office/drawing/2014/main" id="{47AC1123-B605-B8B2-B5C5-36BD5069BD58}"/>
                </a:ext>
              </a:extLst>
            </p:cNvPr>
            <p:cNvSpPr txBox="1"/>
            <p:nvPr/>
          </p:nvSpPr>
          <p:spPr>
            <a:xfrm>
              <a:off x="879770" y="4659538"/>
              <a:ext cx="7553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CLP cells</a:t>
              </a:r>
            </a:p>
          </p:txBody>
        </p:sp>
        <p:sp>
          <p:nvSpPr>
            <p:cNvPr id="334" name="TextBox 333">
              <a:extLst>
                <a:ext uri="{FF2B5EF4-FFF2-40B4-BE49-F238E27FC236}">
                  <a16:creationId xmlns:a16="http://schemas.microsoft.com/office/drawing/2014/main" id="{55ACFD59-6976-CB60-5FAF-B5F1621A84F9}"/>
                </a:ext>
              </a:extLst>
            </p:cNvPr>
            <p:cNvSpPr txBox="1"/>
            <p:nvPr/>
          </p:nvSpPr>
          <p:spPr>
            <a:xfrm>
              <a:off x="1831405" y="5249188"/>
              <a:ext cx="10278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en-GB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pRB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10kDa</a:t>
              </a:r>
            </a:p>
          </p:txBody>
        </p:sp>
        <p:sp>
          <p:nvSpPr>
            <p:cNvPr id="341" name="Right Bracket 340">
              <a:extLst>
                <a:ext uri="{FF2B5EF4-FFF2-40B4-BE49-F238E27FC236}">
                  <a16:creationId xmlns:a16="http://schemas.microsoft.com/office/drawing/2014/main" id="{F6F33509-2CA4-1FDC-E64B-A44D72331D05}"/>
                </a:ext>
              </a:extLst>
            </p:cNvPr>
            <p:cNvSpPr/>
            <p:nvPr/>
          </p:nvSpPr>
          <p:spPr>
            <a:xfrm rot="16200000">
              <a:off x="1279592" y="4351645"/>
              <a:ext cx="45719" cy="1157229"/>
            </a:xfrm>
            <a:prstGeom prst="righ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pic>
        <p:nvPicPr>
          <p:cNvPr id="295" name="Picture 294" descr="A close-up of a test tube&#10;&#10;Description automatically generated">
            <a:extLst>
              <a:ext uri="{FF2B5EF4-FFF2-40B4-BE49-F238E27FC236}">
                <a16:creationId xmlns:a16="http://schemas.microsoft.com/office/drawing/2014/main" id="{9B994843-C1AB-9F97-9EA5-A5932168978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184" t="19355" r="15699" b="55405"/>
          <a:stretch/>
        </p:blipFill>
        <p:spPr>
          <a:xfrm>
            <a:off x="2228853" y="1848400"/>
            <a:ext cx="4549878" cy="103238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6" name="Picture 295" descr="A black and white image of a rectangular object&#10;&#10;Description automatically generated">
            <a:extLst>
              <a:ext uri="{FF2B5EF4-FFF2-40B4-BE49-F238E27FC236}">
                <a16:creationId xmlns:a16="http://schemas.microsoft.com/office/drawing/2014/main" id="{E7FEF639-11A8-1C8C-08FE-4B924D47CE03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59" t="15657" r="16323" b="44761"/>
          <a:stretch/>
        </p:blipFill>
        <p:spPr>
          <a:xfrm>
            <a:off x="1763225" y="3289660"/>
            <a:ext cx="4719484" cy="199840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7" name="Picture 296" descr="A close-up of a test&#10;&#10;Description automatically generated">
            <a:extLst>
              <a:ext uri="{FF2B5EF4-FFF2-40B4-BE49-F238E27FC236}">
                <a16:creationId xmlns:a16="http://schemas.microsoft.com/office/drawing/2014/main" id="{EAD973AB-9BBB-2FFC-1AF2-2149D3742570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31" t="17593" r="7857" b="41224"/>
          <a:stretch/>
        </p:blipFill>
        <p:spPr>
          <a:xfrm>
            <a:off x="1372394" y="5714999"/>
            <a:ext cx="5338915" cy="2234381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98306750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Title 1">
            <a:extLst>
              <a:ext uri="{FF2B5EF4-FFF2-40B4-BE49-F238E27FC236}">
                <a16:creationId xmlns:a16="http://schemas.microsoft.com/office/drawing/2014/main" id="{68A70B02-7EB9-0661-02E3-D7FEEE1A3328}"/>
              </a:ext>
            </a:extLst>
          </p:cNvPr>
          <p:cNvSpPr txBox="1">
            <a:spLocks/>
          </p:cNvSpPr>
          <p:nvPr/>
        </p:nvSpPr>
        <p:spPr>
          <a:xfrm>
            <a:off x="277086" y="-1505"/>
            <a:ext cx="6188736" cy="8837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100" b="1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16  Niclosamide treatment decreases the levels of PRH, p21, and Cyclin D1 in RBE and KKU-M055 cells and increase the levels of cleaved caspase3 in KKU-M055 cells. 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476793" y="1109252"/>
            <a:ext cx="2338675" cy="2648868"/>
            <a:chOff x="611423" y="931049"/>
            <a:chExt cx="2338675" cy="2648868"/>
          </a:xfrm>
        </p:grpSpPr>
        <p:pic>
          <p:nvPicPr>
            <p:cNvPr id="56" name="Content Placeholder 4" descr="A close-up of a test&#10;&#10;Description automatically generated">
              <a:extLst>
                <a:ext uri="{FF2B5EF4-FFF2-40B4-BE49-F238E27FC236}">
                  <a16:creationId xmlns:a16="http://schemas.microsoft.com/office/drawing/2014/main" id="{C3F7BC3D-4B6B-752E-D07E-01D252A7724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315" t="36106" r="38614" b="54507"/>
            <a:stretch/>
          </p:blipFill>
          <p:spPr>
            <a:xfrm>
              <a:off x="634520" y="1450134"/>
              <a:ext cx="1480242" cy="36647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1" name="Content Placeholder 4" descr="A close-up of a test&#10;&#10;Description automatically generated">
              <a:extLst>
                <a:ext uri="{FF2B5EF4-FFF2-40B4-BE49-F238E27FC236}">
                  <a16:creationId xmlns:a16="http://schemas.microsoft.com/office/drawing/2014/main" id="{B46E02CB-FA67-A5A3-A89D-33023A5B5BF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361" t="27373" r="38093" b="63860"/>
            <a:stretch/>
          </p:blipFill>
          <p:spPr>
            <a:xfrm>
              <a:off x="632624" y="2262221"/>
              <a:ext cx="1480242" cy="26240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B1AF1002-B6D2-E7F0-6AE3-FC6DA05B1894}"/>
                </a:ext>
              </a:extLst>
            </p:cNvPr>
            <p:cNvSpPr txBox="1"/>
            <p:nvPr/>
          </p:nvSpPr>
          <p:spPr>
            <a:xfrm>
              <a:off x="2079344" y="1524263"/>
              <a:ext cx="5180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 PRH</a:t>
              </a:r>
            </a:p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35kDa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3EB1D88C-E981-125D-EA21-57AEDB76D148}"/>
                </a:ext>
              </a:extLst>
            </p:cNvPr>
            <p:cNvSpPr txBox="1"/>
            <p:nvPr/>
          </p:nvSpPr>
          <p:spPr>
            <a:xfrm>
              <a:off x="2079344" y="2281386"/>
              <a:ext cx="6142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en-GB" sz="900" dirty="0">
                  <a:latin typeface="Symbol" panose="05050102010706020507" pitchFamily="18" charset="2"/>
                  <a:cs typeface="Arial" panose="020B0604020202020204" pitchFamily="34" charset="0"/>
                </a:rPr>
                <a:t>b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42kDa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63239973-609A-E357-A336-35854593EC8E}"/>
                </a:ext>
              </a:extLst>
            </p:cNvPr>
            <p:cNvSpPr txBox="1"/>
            <p:nvPr/>
          </p:nvSpPr>
          <p:spPr>
            <a:xfrm>
              <a:off x="611423" y="1228722"/>
              <a:ext cx="15969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VC   1</a:t>
              </a:r>
              <a:r>
                <a:rPr lang="el-GR" sz="8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M    2</a:t>
              </a:r>
              <a:r>
                <a:rPr lang="el-GR" sz="8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M    4</a:t>
              </a:r>
              <a:r>
                <a:rPr lang="el-GR" sz="8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M    8</a:t>
              </a:r>
              <a:r>
                <a:rPr lang="el-GR" sz="8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M 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68CC9E78-2ABD-0B02-D3B5-14768E217B65}"/>
                </a:ext>
              </a:extLst>
            </p:cNvPr>
            <p:cNvSpPr txBox="1"/>
            <p:nvPr/>
          </p:nvSpPr>
          <p:spPr>
            <a:xfrm>
              <a:off x="1034984" y="931049"/>
              <a:ext cx="95571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Niclosamide</a:t>
              </a:r>
              <a:endParaRPr lang="en-GB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Right Bracket 33">
              <a:extLst>
                <a:ext uri="{FF2B5EF4-FFF2-40B4-BE49-F238E27FC236}">
                  <a16:creationId xmlns:a16="http://schemas.microsoft.com/office/drawing/2014/main" id="{F6F33509-2CA4-1FDC-E64B-A44D72331D05}"/>
                </a:ext>
              </a:extLst>
            </p:cNvPr>
            <p:cNvSpPr/>
            <p:nvPr/>
          </p:nvSpPr>
          <p:spPr>
            <a:xfrm rot="16200000">
              <a:off x="1477870" y="632190"/>
              <a:ext cx="45719" cy="1157229"/>
            </a:xfrm>
            <a:prstGeom prst="righ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33D58079-69FA-1A3D-972C-6DBE857EBFAA}"/>
                </a:ext>
              </a:extLst>
            </p:cNvPr>
            <p:cNvSpPr txBox="1"/>
            <p:nvPr/>
          </p:nvSpPr>
          <p:spPr>
            <a:xfrm>
              <a:off x="2079344" y="2826887"/>
              <a:ext cx="7489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 Cyclin D1</a:t>
              </a:r>
            </a:p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35kDa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E7224E74-66F1-E35E-CDF6-445188F5A550}"/>
                </a:ext>
              </a:extLst>
            </p:cNvPr>
            <p:cNvSpPr txBox="1"/>
            <p:nvPr/>
          </p:nvSpPr>
          <p:spPr>
            <a:xfrm>
              <a:off x="2079344" y="3210585"/>
              <a:ext cx="6014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en-GB" sz="900" dirty="0">
                  <a:latin typeface="Symbol" panose="05050102010706020507" pitchFamily="18" charset="2"/>
                  <a:cs typeface="Arial" panose="020B0604020202020204" pitchFamily="34" charset="0"/>
                </a:rPr>
                <a:t>b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42kDa</a:t>
              </a:r>
            </a:p>
          </p:txBody>
        </p:sp>
        <p:pic>
          <p:nvPicPr>
            <p:cNvPr id="79" name="Picture 78" descr="A close-up of several black dots&#10;&#10;Description automatically generated">
              <a:extLst>
                <a:ext uri="{FF2B5EF4-FFF2-40B4-BE49-F238E27FC236}">
                  <a16:creationId xmlns:a16="http://schemas.microsoft.com/office/drawing/2014/main" id="{D50D9381-C5B4-AB26-3206-616A8E41DC3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636" t="21603" r="24483" b="69563"/>
            <a:stretch/>
          </p:blipFill>
          <p:spPr>
            <a:xfrm>
              <a:off x="623632" y="3171450"/>
              <a:ext cx="1498224" cy="3556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4" name="Content Placeholder 4" descr="A close-up of a test&#10;&#10;Description automatically generated">
              <a:extLst>
                <a:ext uri="{FF2B5EF4-FFF2-40B4-BE49-F238E27FC236}">
                  <a16:creationId xmlns:a16="http://schemas.microsoft.com/office/drawing/2014/main" id="{A039BD34-A870-6E31-34EB-6E93C80F472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306" t="22536" r="24818" b="68729"/>
            <a:stretch/>
          </p:blipFill>
          <p:spPr>
            <a:xfrm>
              <a:off x="632624" y="2732792"/>
              <a:ext cx="1498224" cy="39874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522C58A5-F000-495F-F702-483ADBC9D6FB}"/>
                </a:ext>
              </a:extLst>
            </p:cNvPr>
            <p:cNvSpPr txBox="1"/>
            <p:nvPr/>
          </p:nvSpPr>
          <p:spPr>
            <a:xfrm>
              <a:off x="2079344" y="1973410"/>
              <a:ext cx="87075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en-GB" sz="900" dirty="0">
                  <a:latin typeface="Symbol" panose="05050102010706020507" pitchFamily="18" charset="2"/>
                  <a:cs typeface="Arial" panose="020B0604020202020204" pitchFamily="34" charset="0"/>
                </a:rPr>
                <a:t>b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catenin</a:t>
              </a:r>
            </a:p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90kDa </a:t>
              </a:r>
            </a:p>
          </p:txBody>
        </p:sp>
        <p:pic>
          <p:nvPicPr>
            <p:cNvPr id="60" name="Content Placeholder 4" descr="A close-up of a test&#10;&#10;Description automatically generated">
              <a:extLst>
                <a:ext uri="{FF2B5EF4-FFF2-40B4-BE49-F238E27FC236}">
                  <a16:creationId xmlns:a16="http://schemas.microsoft.com/office/drawing/2014/main" id="{A5FA3401-2D98-ECCF-5606-3D094E76E6F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365" t="33050" r="35030" b="59874"/>
            <a:stretch/>
          </p:blipFill>
          <p:spPr>
            <a:xfrm>
              <a:off x="634520" y="1862953"/>
              <a:ext cx="1480798" cy="35148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63" name="TextBox 62"/>
          <p:cNvSpPr txBox="1"/>
          <p:nvPr/>
        </p:nvSpPr>
        <p:spPr>
          <a:xfrm>
            <a:off x="259700" y="849708"/>
            <a:ext cx="5362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91180"/>
            <a:r>
              <a:rPr lang="en-GB" sz="1000" b="1" dirty="0">
                <a:solidFill>
                  <a:prstClr val="black"/>
                </a:solidFill>
                <a:latin typeface="Calibri"/>
              </a:rPr>
              <a:t>A   </a:t>
            </a:r>
          </a:p>
        </p:txBody>
      </p:sp>
      <p:pic>
        <p:nvPicPr>
          <p:cNvPr id="67" name="Content Placeholder 4" descr="A close-up of a test&#10;&#10;Description automatically generated">
            <a:extLst>
              <a:ext uri="{FF2B5EF4-FFF2-40B4-BE49-F238E27FC236}">
                <a16:creationId xmlns:a16="http://schemas.microsoft.com/office/drawing/2014/main" id="{C3F7BC3D-4B6B-752E-D07E-01D252A7724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52" t="21268" r="30096" b="46432"/>
          <a:stretch/>
        </p:blipFill>
        <p:spPr>
          <a:xfrm>
            <a:off x="4041057" y="932761"/>
            <a:ext cx="2190135" cy="126098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8" name="Content Placeholder 4" descr="A close-up of a test&#10;&#10;Description automatically generated">
            <a:extLst>
              <a:ext uri="{FF2B5EF4-FFF2-40B4-BE49-F238E27FC236}">
                <a16:creationId xmlns:a16="http://schemas.microsoft.com/office/drawing/2014/main" id="{A5FA3401-2D98-ECCF-5606-3D094E76E6F6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19" t="22536" r="27375" b="55494"/>
          <a:stretch/>
        </p:blipFill>
        <p:spPr>
          <a:xfrm>
            <a:off x="4041057" y="2455426"/>
            <a:ext cx="2212257" cy="10913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3" name="Content Placeholder 4" descr="A close-up of a test&#10;&#10;Description automatically generated">
            <a:extLst>
              <a:ext uri="{FF2B5EF4-FFF2-40B4-BE49-F238E27FC236}">
                <a16:creationId xmlns:a16="http://schemas.microsoft.com/office/drawing/2014/main" id="{B46E02CB-FA67-A5A3-A89D-33023A5B5BF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50" t="16137" r="25342" b="43213"/>
          <a:stretch/>
        </p:blipFill>
        <p:spPr>
          <a:xfrm>
            <a:off x="3920756" y="3884214"/>
            <a:ext cx="2374490" cy="121674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5" name="Content Placeholder 4" descr="A close-up of a test&#10;&#10;Description automatically generated">
            <a:extLst>
              <a:ext uri="{FF2B5EF4-FFF2-40B4-BE49-F238E27FC236}">
                <a16:creationId xmlns:a16="http://schemas.microsoft.com/office/drawing/2014/main" id="{A039BD34-A870-6E31-34EB-6E93C80F472B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39" t="16197" r="11666" b="66518"/>
          <a:stretch/>
        </p:blipFill>
        <p:spPr>
          <a:xfrm>
            <a:off x="463100" y="5380375"/>
            <a:ext cx="4704735" cy="78903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7" name="Picture 76" descr="A close-up of several black dots&#10;&#10;Description automatically generated">
            <a:extLst>
              <a:ext uri="{FF2B5EF4-FFF2-40B4-BE49-F238E27FC236}">
                <a16:creationId xmlns:a16="http://schemas.microsoft.com/office/drawing/2014/main" id="{D50D9381-C5B4-AB26-3206-616A8E41DC30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09" t="10825" r="4094" b="62612"/>
          <a:stretch/>
        </p:blipFill>
        <p:spPr>
          <a:xfrm>
            <a:off x="476793" y="6497533"/>
            <a:ext cx="5073445" cy="1069259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89365232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Title 1">
            <a:extLst>
              <a:ext uri="{FF2B5EF4-FFF2-40B4-BE49-F238E27FC236}">
                <a16:creationId xmlns:a16="http://schemas.microsoft.com/office/drawing/2014/main" id="{68A70B02-7EB9-0661-02E3-D7FEEE1A3328}"/>
              </a:ext>
            </a:extLst>
          </p:cNvPr>
          <p:cNvSpPr txBox="1">
            <a:spLocks/>
          </p:cNvSpPr>
          <p:nvPr/>
        </p:nvSpPr>
        <p:spPr>
          <a:xfrm>
            <a:off x="277086" y="-1505"/>
            <a:ext cx="6188736" cy="8837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100" b="1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16  Niclosamide treatment decreases the levels of PRH, p21, and Cyclin D1 in RBE and KKU-M055 cells and increase the levels of cleaved caspase3 in KKU-M055 cells. 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522C58A5-F000-495F-F702-483ADBC9D6FB}"/>
              </a:ext>
            </a:extLst>
          </p:cNvPr>
          <p:cNvSpPr txBox="1"/>
          <p:nvPr/>
        </p:nvSpPr>
        <p:spPr>
          <a:xfrm>
            <a:off x="2052563" y="1918516"/>
            <a:ext cx="8707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GB" sz="9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catenin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0kDa 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9ACC36BA-E171-17E8-72C3-D6D00658FFEF}"/>
              </a:ext>
            </a:extLst>
          </p:cNvPr>
          <p:cNvSpPr txBox="1"/>
          <p:nvPr/>
        </p:nvSpPr>
        <p:spPr>
          <a:xfrm>
            <a:off x="2052563" y="2237016"/>
            <a:ext cx="6014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GB" sz="9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2kDa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B1AF1002-B6D2-E7F0-6AE3-FC6DA05B1894}"/>
              </a:ext>
            </a:extLst>
          </p:cNvPr>
          <p:cNvSpPr txBox="1"/>
          <p:nvPr/>
        </p:nvSpPr>
        <p:spPr>
          <a:xfrm>
            <a:off x="2052563" y="1544652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 PRH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63239973-609A-E357-A336-35854593EC8E}"/>
              </a:ext>
            </a:extLst>
          </p:cNvPr>
          <p:cNvSpPr txBox="1"/>
          <p:nvPr/>
        </p:nvSpPr>
        <p:spPr>
          <a:xfrm>
            <a:off x="593858" y="1275140"/>
            <a:ext cx="15969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VC   1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M    2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M    4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M    8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M 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68CC9E78-2ABD-0B02-D3B5-14768E217B65}"/>
              </a:ext>
            </a:extLst>
          </p:cNvPr>
          <p:cNvSpPr txBox="1"/>
          <p:nvPr/>
        </p:nvSpPr>
        <p:spPr>
          <a:xfrm>
            <a:off x="1039243" y="953200"/>
            <a:ext cx="95571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Niclosamide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Right Bracket 97">
            <a:extLst>
              <a:ext uri="{FF2B5EF4-FFF2-40B4-BE49-F238E27FC236}">
                <a16:creationId xmlns:a16="http://schemas.microsoft.com/office/drawing/2014/main" id="{F6F33509-2CA4-1FDC-E64B-A44D72331D05}"/>
              </a:ext>
            </a:extLst>
          </p:cNvPr>
          <p:cNvSpPr/>
          <p:nvPr/>
        </p:nvSpPr>
        <p:spPr>
          <a:xfrm rot="16200000">
            <a:off x="1460305" y="678607"/>
            <a:ext cx="45719" cy="1157229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100" name="Picture 99">
            <a:extLst>
              <a:ext uri="{FF2B5EF4-FFF2-40B4-BE49-F238E27FC236}">
                <a16:creationId xmlns:a16="http://schemas.microsoft.com/office/drawing/2014/main" id="{0EC6BAC2-2482-A5EA-0CBC-EA34953A78A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1458" t="41749" r="59112" b="41605"/>
          <a:stretch/>
        </p:blipFill>
        <p:spPr>
          <a:xfrm>
            <a:off x="602849" y="1465440"/>
            <a:ext cx="1480242" cy="35667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2" name="Content Placeholder 4" descr="A close-up of a test&#10;&#10;Description automatically generated">
            <a:extLst>
              <a:ext uri="{FF2B5EF4-FFF2-40B4-BE49-F238E27FC236}">
                <a16:creationId xmlns:a16="http://schemas.microsoft.com/office/drawing/2014/main" id="{AA813E88-8984-3837-8CF2-31D980B0756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862" t="26192" r="30990" b="63540"/>
          <a:stretch/>
        </p:blipFill>
        <p:spPr>
          <a:xfrm>
            <a:off x="602849" y="2238091"/>
            <a:ext cx="1489234" cy="28615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3" name="Content Placeholder 4" descr="A black and white image of a rectangular object&#10;&#10;Description automatically generated">
            <a:extLst>
              <a:ext uri="{FF2B5EF4-FFF2-40B4-BE49-F238E27FC236}">
                <a16:creationId xmlns:a16="http://schemas.microsoft.com/office/drawing/2014/main" id="{BBE7491C-6FF0-9643-FE9B-4CA0986BA4A6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496" t="36328" r="29917" b="51615"/>
          <a:stretch/>
        </p:blipFill>
        <p:spPr>
          <a:xfrm>
            <a:off x="602849" y="1865794"/>
            <a:ext cx="1489234" cy="32939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7" name="TextBox 106">
            <a:extLst>
              <a:ext uri="{FF2B5EF4-FFF2-40B4-BE49-F238E27FC236}">
                <a16:creationId xmlns:a16="http://schemas.microsoft.com/office/drawing/2014/main" id="{B4F7631F-DCD3-87FC-CAA1-8C866F4AC5CE}"/>
              </a:ext>
            </a:extLst>
          </p:cNvPr>
          <p:cNvSpPr txBox="1"/>
          <p:nvPr/>
        </p:nvSpPr>
        <p:spPr>
          <a:xfrm>
            <a:off x="2052563" y="3550604"/>
            <a:ext cx="9476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Clved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Casp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7kDa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44DCE02A-B991-0F4E-E081-9570476470B2}"/>
              </a:ext>
            </a:extLst>
          </p:cNvPr>
          <p:cNvSpPr txBox="1"/>
          <p:nvPr/>
        </p:nvSpPr>
        <p:spPr>
          <a:xfrm>
            <a:off x="2052563" y="3949774"/>
            <a:ext cx="614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GB" sz="9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2kDa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CEA94F71-F668-F6E3-5933-B1E9117B50D1}"/>
              </a:ext>
            </a:extLst>
          </p:cNvPr>
          <p:cNvSpPr txBox="1"/>
          <p:nvPr/>
        </p:nvSpPr>
        <p:spPr>
          <a:xfrm>
            <a:off x="2052563" y="2661400"/>
            <a:ext cx="748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 Cyclin D1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A6A75C3D-2FE6-5E32-3F9D-92F2D131CE80}"/>
              </a:ext>
            </a:extLst>
          </p:cNvPr>
          <p:cNvSpPr txBox="1"/>
          <p:nvPr/>
        </p:nvSpPr>
        <p:spPr>
          <a:xfrm>
            <a:off x="2052563" y="3071655"/>
            <a:ext cx="6014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GB" sz="9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2kDa</a:t>
            </a:r>
          </a:p>
        </p:txBody>
      </p:sp>
      <p:pic>
        <p:nvPicPr>
          <p:cNvPr id="120" name="Picture 119" descr="A close-up of several black dots&#10;&#10;Description automatically generated">
            <a:extLst>
              <a:ext uri="{FF2B5EF4-FFF2-40B4-BE49-F238E27FC236}">
                <a16:creationId xmlns:a16="http://schemas.microsoft.com/office/drawing/2014/main" id="{6DF537DE-CC96-130C-381F-B9825D52F175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103" t="66225" r="53544" b="21836"/>
          <a:stretch/>
        </p:blipFill>
        <p:spPr>
          <a:xfrm>
            <a:off x="602849" y="3907519"/>
            <a:ext cx="1498224" cy="33578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1" name="Content Placeholder 4" descr="A close-up of a test&#10;&#10;Description automatically generated">
            <a:extLst>
              <a:ext uri="{FF2B5EF4-FFF2-40B4-BE49-F238E27FC236}">
                <a16:creationId xmlns:a16="http://schemas.microsoft.com/office/drawing/2014/main" id="{999C4EA7-B31F-BC1E-0318-5A0248E2D7E4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50" t="50960" r="48933" b="37197"/>
          <a:stretch/>
        </p:blipFill>
        <p:spPr>
          <a:xfrm>
            <a:off x="602849" y="3487064"/>
            <a:ext cx="1498224" cy="36621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2" name="Picture 121" descr="A close-up of several black dots&#10;&#10;Description automatically generated">
            <a:extLst>
              <a:ext uri="{FF2B5EF4-FFF2-40B4-BE49-F238E27FC236}">
                <a16:creationId xmlns:a16="http://schemas.microsoft.com/office/drawing/2014/main" id="{5832C1EF-DBC0-FCDE-ED54-6468A3FD1E14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60" t="19752" r="52324" b="68748"/>
          <a:stretch/>
        </p:blipFill>
        <p:spPr>
          <a:xfrm>
            <a:off x="602849" y="3030732"/>
            <a:ext cx="1498223" cy="355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3" name="Content Placeholder 4" descr="A close-up of a film&#10;&#10;Description automatically generated">
            <a:extLst>
              <a:ext uri="{FF2B5EF4-FFF2-40B4-BE49-F238E27FC236}">
                <a16:creationId xmlns:a16="http://schemas.microsoft.com/office/drawing/2014/main" id="{DA8D0895-34ED-FDE1-4E92-EA127D8FE9C3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056" t="32453" r="49722" b="59545"/>
          <a:stretch/>
        </p:blipFill>
        <p:spPr>
          <a:xfrm>
            <a:off x="602849" y="2598206"/>
            <a:ext cx="1498224" cy="38962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4" name="TextBox 133"/>
          <p:cNvSpPr txBox="1"/>
          <p:nvPr/>
        </p:nvSpPr>
        <p:spPr>
          <a:xfrm>
            <a:off x="355565" y="960766"/>
            <a:ext cx="5362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91180"/>
            <a:r>
              <a:rPr lang="en-GB" sz="1000" b="1" dirty="0">
                <a:solidFill>
                  <a:prstClr val="black"/>
                </a:solidFill>
                <a:latin typeface="Calibri"/>
              </a:rPr>
              <a:t>C   </a:t>
            </a:r>
          </a:p>
        </p:txBody>
      </p:sp>
      <p:pic>
        <p:nvPicPr>
          <p:cNvPr id="37" name="Picture 36">
            <a:extLst>
              <a:ext uri="{FF2B5EF4-FFF2-40B4-BE49-F238E27FC236}">
                <a16:creationId xmlns:a16="http://schemas.microsoft.com/office/drawing/2014/main" id="{0EC6BAC2-2482-A5EA-0CBC-EA34953A78A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7353" t="24345" r="54287" b="17836"/>
          <a:stretch/>
        </p:blipFill>
        <p:spPr>
          <a:xfrm>
            <a:off x="4144297" y="1112703"/>
            <a:ext cx="2160638" cy="123886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Content Placeholder 4" descr="A black and white image of a rectangular object&#10;&#10;Description automatically generated">
            <a:extLst>
              <a:ext uri="{FF2B5EF4-FFF2-40B4-BE49-F238E27FC236}">
                <a16:creationId xmlns:a16="http://schemas.microsoft.com/office/drawing/2014/main" id="{BBE7491C-6FF0-9643-FE9B-4CA0986BA4A6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536" t="24846" r="16116" b="42225"/>
          <a:stretch/>
        </p:blipFill>
        <p:spPr>
          <a:xfrm>
            <a:off x="3982065" y="2713267"/>
            <a:ext cx="2529348" cy="89965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9" name="Content Placeholder 4" descr="A close-up of a test&#10;&#10;Description automatically generated">
            <a:extLst>
              <a:ext uri="{FF2B5EF4-FFF2-40B4-BE49-F238E27FC236}">
                <a16:creationId xmlns:a16="http://schemas.microsoft.com/office/drawing/2014/main" id="{AA813E88-8984-3837-8CF2-31D980B0756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14" t="15422" r="24340" b="47005"/>
          <a:stretch/>
        </p:blipFill>
        <p:spPr>
          <a:xfrm>
            <a:off x="3982065" y="3777364"/>
            <a:ext cx="2485103" cy="104713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0" name="Content Placeholder 4" descr="A close-up of a film&#10;&#10;Description automatically generated">
            <a:extLst>
              <a:ext uri="{FF2B5EF4-FFF2-40B4-BE49-F238E27FC236}">
                <a16:creationId xmlns:a16="http://schemas.microsoft.com/office/drawing/2014/main" id="{DA8D0895-34ED-FDE1-4E92-EA127D8FE9C3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507" t="23366" r="44413" b="54069"/>
          <a:stretch/>
        </p:blipFill>
        <p:spPr>
          <a:xfrm>
            <a:off x="3982065" y="5106409"/>
            <a:ext cx="2617839" cy="109875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1" name="Picture 40" descr="A close-up of several black dots&#10;&#10;Description automatically generated">
            <a:extLst>
              <a:ext uri="{FF2B5EF4-FFF2-40B4-BE49-F238E27FC236}">
                <a16:creationId xmlns:a16="http://schemas.microsoft.com/office/drawing/2014/main" id="{5832C1EF-DBC0-FCDE-ED54-6468A3FD1E14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54" t="14415" r="49158" b="63167"/>
          <a:stretch/>
        </p:blipFill>
        <p:spPr>
          <a:xfrm>
            <a:off x="4291780" y="6376083"/>
            <a:ext cx="2072148" cy="69317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2" name="Content Placeholder 4" descr="A close-up of a test&#10;&#10;Description automatically generated">
            <a:extLst>
              <a:ext uri="{FF2B5EF4-FFF2-40B4-BE49-F238E27FC236}">
                <a16:creationId xmlns:a16="http://schemas.microsoft.com/office/drawing/2014/main" id="{999C4EA7-B31F-BC1E-0318-5A0248E2D7E4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74" t="39819" r="18499" b="30133"/>
          <a:stretch/>
        </p:blipFill>
        <p:spPr>
          <a:xfrm>
            <a:off x="54732" y="5287229"/>
            <a:ext cx="3650226" cy="92914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3" name="Picture 42" descr="A close-up of several black dots&#10;&#10;Description automatically generated">
            <a:extLst>
              <a:ext uri="{FF2B5EF4-FFF2-40B4-BE49-F238E27FC236}">
                <a16:creationId xmlns:a16="http://schemas.microsoft.com/office/drawing/2014/main" id="{6DF537DE-CC96-130C-381F-B9825D52F175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24" t="64352" r="19897" b="11789"/>
          <a:stretch/>
        </p:blipFill>
        <p:spPr>
          <a:xfrm>
            <a:off x="54732" y="6380633"/>
            <a:ext cx="3790335" cy="671051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54944773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0B8E41D-B1B5-CC6D-607B-825E63E7639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756E53B-E8DE-8D47-B2DF-3A162BAAF2A3}"/>
              </a:ext>
            </a:extLst>
          </p:cNvPr>
          <p:cNvSpPr txBox="1"/>
          <p:nvPr/>
        </p:nvSpPr>
        <p:spPr>
          <a:xfrm>
            <a:off x="456310" y="325828"/>
            <a:ext cx="527099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17  Proteasome inhibition restores PRH protein levels in RBE cells. 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537141" y="1988714"/>
            <a:ext cx="5362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91180"/>
            <a:r>
              <a:rPr lang="en-GB" sz="1000" b="1" dirty="0">
                <a:solidFill>
                  <a:prstClr val="black"/>
                </a:solidFill>
                <a:latin typeface="Calibri"/>
              </a:rPr>
              <a:t>B   </a:t>
            </a:r>
          </a:p>
        </p:txBody>
      </p:sp>
      <p:grpSp>
        <p:nvGrpSpPr>
          <p:cNvPr id="9" name="Group 8"/>
          <p:cNvGrpSpPr/>
          <p:nvPr/>
        </p:nvGrpSpPr>
        <p:grpSpPr>
          <a:xfrm>
            <a:off x="774151" y="2250222"/>
            <a:ext cx="1670578" cy="1559529"/>
            <a:chOff x="-1613449" y="3288447"/>
            <a:chExt cx="1670578" cy="1559529"/>
          </a:xfrm>
        </p:grpSpPr>
        <p:grpSp>
          <p:nvGrpSpPr>
            <p:cNvPr id="7" name="Group 6"/>
            <p:cNvGrpSpPr/>
            <p:nvPr/>
          </p:nvGrpSpPr>
          <p:grpSpPr>
            <a:xfrm>
              <a:off x="-1613449" y="3743271"/>
              <a:ext cx="1084932" cy="1104705"/>
              <a:chOff x="-1613449" y="3743271"/>
              <a:chExt cx="1084932" cy="1104705"/>
            </a:xfrm>
          </p:grpSpPr>
          <p:pic>
            <p:nvPicPr>
              <p:cNvPr id="18" name="Picture 17" descr="A close-up of a test tube&#10;&#10;Description automatically generated">
                <a:extLst>
                  <a:ext uri="{FF2B5EF4-FFF2-40B4-BE49-F238E27FC236}">
                    <a16:creationId xmlns:a16="http://schemas.microsoft.com/office/drawing/2014/main" id="{CD1682C5-F23A-E2FF-7CF7-F75AD42B7BC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939" t="33268" r="44216" b="51125"/>
              <a:stretch/>
            </p:blipFill>
            <p:spPr>
              <a:xfrm>
                <a:off x="-1613449" y="3743271"/>
                <a:ext cx="1084932" cy="53368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9" name="Picture 18" descr="A close-up of a test&#10;&#10;Description automatically generated">
                <a:extLst>
                  <a:ext uri="{FF2B5EF4-FFF2-40B4-BE49-F238E27FC236}">
                    <a16:creationId xmlns:a16="http://schemas.microsoft.com/office/drawing/2014/main" id="{406469FC-2796-A578-AD31-E1E58A02586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885" t="27521" r="49015" b="58216"/>
              <a:stretch/>
            </p:blipFill>
            <p:spPr>
              <a:xfrm>
                <a:off x="-1613445" y="4346343"/>
                <a:ext cx="1084928" cy="50163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grpSp>
          <p:nvGrpSpPr>
            <p:cNvPr id="21" name="Group 20"/>
            <p:cNvGrpSpPr/>
            <p:nvPr/>
          </p:nvGrpSpPr>
          <p:grpSpPr>
            <a:xfrm>
              <a:off x="-1588990" y="3288447"/>
              <a:ext cx="1646119" cy="1558446"/>
              <a:chOff x="2883715" y="3695092"/>
              <a:chExt cx="1646119" cy="1558446"/>
            </a:xfrm>
          </p:grpSpPr>
          <p:grpSp>
            <p:nvGrpSpPr>
              <p:cNvPr id="24" name="Group 23">
                <a:extLst>
                  <a:ext uri="{FF2B5EF4-FFF2-40B4-BE49-F238E27FC236}">
                    <a16:creationId xmlns:a16="http://schemas.microsoft.com/office/drawing/2014/main" id="{943DA744-EB62-A6FD-C0B3-B6428EA86F17}"/>
                  </a:ext>
                </a:extLst>
              </p:cNvPr>
              <p:cNvGrpSpPr/>
              <p:nvPr/>
            </p:nvGrpSpPr>
            <p:grpSpPr>
              <a:xfrm>
                <a:off x="2883715" y="3695092"/>
                <a:ext cx="1079491" cy="446837"/>
                <a:chOff x="4948348" y="2821026"/>
                <a:chExt cx="1079491" cy="446837"/>
              </a:xfrm>
            </p:grpSpPr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2B7CCE32-ABFC-234B-1080-1D14A04E07A4}"/>
                    </a:ext>
                  </a:extLst>
                </p:cNvPr>
                <p:cNvSpPr txBox="1"/>
                <p:nvPr/>
              </p:nvSpPr>
              <p:spPr>
                <a:xfrm>
                  <a:off x="4948348" y="3052419"/>
                  <a:ext cx="56137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C  NIC</a:t>
                  </a:r>
                </a:p>
              </p:txBody>
            </p:sp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E3A0FE6A-6C97-4A8F-4619-F2487EEEEC26}"/>
                    </a:ext>
                  </a:extLst>
                </p:cNvPr>
                <p:cNvSpPr txBox="1"/>
                <p:nvPr/>
              </p:nvSpPr>
              <p:spPr>
                <a:xfrm>
                  <a:off x="5464487" y="3052419"/>
                  <a:ext cx="56137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C  NIC</a:t>
                  </a:r>
                </a:p>
              </p:txBody>
            </p:sp>
            <p:sp>
              <p:nvSpPr>
                <p:cNvPr id="32" name="Right Bracket 31">
                  <a:extLst>
                    <a:ext uri="{FF2B5EF4-FFF2-40B4-BE49-F238E27FC236}">
                      <a16:creationId xmlns:a16="http://schemas.microsoft.com/office/drawing/2014/main" id="{93752D38-79C2-0D7E-FB0C-A554AD4DE073}"/>
                    </a:ext>
                  </a:extLst>
                </p:cNvPr>
                <p:cNvSpPr/>
                <p:nvPr/>
              </p:nvSpPr>
              <p:spPr>
                <a:xfrm rot="16200000">
                  <a:off x="5735318" y="2779916"/>
                  <a:ext cx="45719" cy="539323"/>
                </a:xfrm>
                <a:prstGeom prst="rightBracket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GB" sz="1400"/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59DDAD2C-0B36-A24A-6A88-89DBA9B5595D}"/>
                    </a:ext>
                  </a:extLst>
                </p:cNvPr>
                <p:cNvSpPr txBox="1"/>
                <p:nvPr/>
              </p:nvSpPr>
              <p:spPr>
                <a:xfrm>
                  <a:off x="5483723" y="2821026"/>
                  <a:ext cx="5229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G132</a:t>
                  </a:r>
                </a:p>
              </p:txBody>
            </p:sp>
          </p:grp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4C8EDE08-F0BA-DDF4-8211-8FE6C1419AFB}"/>
                  </a:ext>
                </a:extLst>
              </p:cNvPr>
              <p:cNvSpPr txBox="1"/>
              <p:nvPr/>
            </p:nvSpPr>
            <p:spPr>
              <a:xfrm>
                <a:off x="3931593" y="4884206"/>
                <a:ext cx="59824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GB" sz="900" dirty="0">
                    <a:latin typeface="Symbol" panose="05050102010706020507" pitchFamily="18" charset="2"/>
                    <a:cs typeface="Arial" panose="020B0604020202020204" pitchFamily="34" charset="0"/>
                  </a:rPr>
                  <a:t> b</a:t>
                </a:r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</a:p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42kDa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55ACFD59-6976-CB60-5FAF-B5F1621A84F9}"/>
                  </a:ext>
                </a:extLst>
              </p:cNvPr>
              <p:cNvSpPr txBox="1"/>
              <p:nvPr/>
            </p:nvSpPr>
            <p:spPr>
              <a:xfrm>
                <a:off x="3922843" y="4277526"/>
                <a:ext cx="59824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 PRH</a:t>
                </a:r>
              </a:p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35kDa</a:t>
                </a:r>
              </a:p>
            </p:txBody>
          </p:sp>
        </p:grpSp>
      </p:grpSp>
      <p:pic>
        <p:nvPicPr>
          <p:cNvPr id="43" name="Picture 42" descr="A close-up of a test tube&#10;&#10;Description automatically generated">
            <a:extLst>
              <a:ext uri="{FF2B5EF4-FFF2-40B4-BE49-F238E27FC236}">
                <a16:creationId xmlns:a16="http://schemas.microsoft.com/office/drawing/2014/main" id="{CD1682C5-F23A-E2FF-7CF7-F75AD42B7BC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31" t="17307" r="16256" b="14334"/>
          <a:stretch/>
        </p:blipFill>
        <p:spPr>
          <a:xfrm>
            <a:off x="3340509" y="2426110"/>
            <a:ext cx="2728451" cy="233761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4" name="Picture 43" descr="A close-up of a test&#10;&#10;Description automatically generated">
            <a:extLst>
              <a:ext uri="{FF2B5EF4-FFF2-40B4-BE49-F238E27FC236}">
                <a16:creationId xmlns:a16="http://schemas.microsoft.com/office/drawing/2014/main" id="{406469FC-2796-A578-AD31-E1E58A02586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327" t="16559" r="21695" b="22844"/>
          <a:stretch/>
        </p:blipFill>
        <p:spPr>
          <a:xfrm>
            <a:off x="3395815" y="5206181"/>
            <a:ext cx="2617838" cy="2131141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66433542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>
            <a:extLst>
              <a:ext uri="{FF2B5EF4-FFF2-40B4-BE49-F238E27FC236}">
                <a16:creationId xmlns:a16="http://schemas.microsoft.com/office/drawing/2014/main" id="{8756E53B-E8DE-8D47-B2DF-3A162BAAF2A3}"/>
              </a:ext>
            </a:extLst>
          </p:cNvPr>
          <p:cNvSpPr txBox="1"/>
          <p:nvPr/>
        </p:nvSpPr>
        <p:spPr>
          <a:xfrm>
            <a:off x="377715" y="390183"/>
            <a:ext cx="49600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18   PRH knockout does not reduce sensitivity to Niclosamide. 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777466" y="561719"/>
            <a:ext cx="1462015" cy="2325149"/>
            <a:chOff x="1180779" y="398494"/>
            <a:chExt cx="1462015" cy="2325149"/>
          </a:xfrm>
        </p:grpSpPr>
        <p:pic>
          <p:nvPicPr>
            <p:cNvPr id="12" name="Picture 11" descr="A screenshot of a computer&#10;&#10;Description automatically generated">
              <a:extLst>
                <a:ext uri="{FF2B5EF4-FFF2-40B4-BE49-F238E27FC236}">
                  <a16:creationId xmlns:a16="http://schemas.microsoft.com/office/drawing/2014/main" id="{F29EAA49-79D2-1CF9-6602-D5905456394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434" t="42348" r="57874" b="14582"/>
            <a:stretch/>
          </p:blipFill>
          <p:spPr>
            <a:xfrm>
              <a:off x="1180779" y="1335939"/>
              <a:ext cx="491163" cy="1368988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5886298-35FC-712E-5A63-FE29CDC16069}"/>
                </a:ext>
              </a:extLst>
            </p:cNvPr>
            <p:cNvSpPr txBox="1"/>
            <p:nvPr/>
          </p:nvSpPr>
          <p:spPr>
            <a:xfrm>
              <a:off x="1614965" y="1905565"/>
              <a:ext cx="6014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en-GB" sz="900" dirty="0">
                  <a:latin typeface="Symbol" panose="05050102010706020507" pitchFamily="18" charset="2"/>
                  <a:cs typeface="Arial" panose="020B0604020202020204" pitchFamily="34" charset="0"/>
                </a:rPr>
                <a:t>b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42kDa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1A03DFF-84E0-CCAB-7BB2-54ECC456E63B}"/>
                </a:ext>
              </a:extLst>
            </p:cNvPr>
            <p:cNvSpPr txBox="1"/>
            <p:nvPr/>
          </p:nvSpPr>
          <p:spPr>
            <a:xfrm>
              <a:off x="1614965" y="2354311"/>
              <a:ext cx="87075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en-GB" sz="900" dirty="0">
                  <a:latin typeface="Symbol" panose="05050102010706020507" pitchFamily="18" charset="2"/>
                  <a:cs typeface="Arial" panose="020B0604020202020204" pitchFamily="34" charset="0"/>
                </a:rPr>
                <a:t>b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tubulin</a:t>
              </a:r>
            </a:p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55kDa 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55ACFD59-6976-CB60-5FAF-B5F1621A84F9}"/>
                </a:ext>
              </a:extLst>
            </p:cNvPr>
            <p:cNvSpPr txBox="1"/>
            <p:nvPr/>
          </p:nvSpPr>
          <p:spPr>
            <a:xfrm>
              <a:off x="1614965" y="1473481"/>
              <a:ext cx="10278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 PRH</a:t>
              </a:r>
            </a:p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35kDa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5ACFD59-6976-CB60-5FAF-B5F1621A84F9}"/>
                </a:ext>
              </a:extLst>
            </p:cNvPr>
            <p:cNvSpPr txBox="1"/>
            <p:nvPr/>
          </p:nvSpPr>
          <p:spPr>
            <a:xfrm rot="18091531">
              <a:off x="992594" y="796993"/>
              <a:ext cx="10278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5ACFD59-6976-CB60-5FAF-B5F1621A84F9}"/>
                </a:ext>
              </a:extLst>
            </p:cNvPr>
            <p:cNvSpPr txBox="1"/>
            <p:nvPr/>
          </p:nvSpPr>
          <p:spPr>
            <a:xfrm rot="18091531">
              <a:off x="1247868" y="796993"/>
              <a:ext cx="10278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PRH KO</a:t>
              </a:r>
            </a:p>
          </p:txBody>
        </p:sp>
      </p:grpSp>
      <p:sp>
        <p:nvSpPr>
          <p:cNvPr id="23" name="Rectangle 22"/>
          <p:cNvSpPr/>
          <p:nvPr/>
        </p:nvSpPr>
        <p:spPr>
          <a:xfrm>
            <a:off x="562759" y="2952822"/>
            <a:ext cx="1383118" cy="6785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7" name="TextBox 26"/>
          <p:cNvSpPr txBox="1"/>
          <p:nvPr/>
        </p:nvSpPr>
        <p:spPr>
          <a:xfrm>
            <a:off x="522992" y="887327"/>
            <a:ext cx="5362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91180"/>
            <a:r>
              <a:rPr lang="en-GB" sz="1000" b="1" dirty="0">
                <a:solidFill>
                  <a:prstClr val="black"/>
                </a:solidFill>
                <a:latin typeface="Calibri"/>
              </a:rPr>
              <a:t>A   </a:t>
            </a:r>
          </a:p>
        </p:txBody>
      </p:sp>
      <p:sp>
        <p:nvSpPr>
          <p:cNvPr id="33" name="Rectangle 32"/>
          <p:cNvSpPr/>
          <p:nvPr/>
        </p:nvSpPr>
        <p:spPr>
          <a:xfrm>
            <a:off x="1936537" y="1210457"/>
            <a:ext cx="529228" cy="259050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35" name="Picture 34" descr="A screenshot of a computer&#10;&#10;Description automatically generated">
            <a:extLst>
              <a:ext uri="{FF2B5EF4-FFF2-40B4-BE49-F238E27FC236}">
                <a16:creationId xmlns:a16="http://schemas.microsoft.com/office/drawing/2014/main" id="{F29EAA49-79D2-1CF9-6602-D5905456394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368" t="26196" r="5635" b="7916"/>
          <a:stretch/>
        </p:blipFill>
        <p:spPr>
          <a:xfrm>
            <a:off x="2362919" y="1636706"/>
            <a:ext cx="4181166" cy="20942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47807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le 1">
            <a:extLst>
              <a:ext uri="{FF2B5EF4-FFF2-40B4-BE49-F238E27FC236}">
                <a16:creationId xmlns:a16="http://schemas.microsoft.com/office/drawing/2014/main" id="{68A70B02-7EB9-0661-02E3-D7FEEE1A33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38681" y="-97218"/>
            <a:ext cx="5915025" cy="1193819"/>
          </a:xfrm>
        </p:spPr>
        <p:txBody>
          <a:bodyPr>
            <a:normAutofit/>
          </a:bodyPr>
          <a:lstStyle/>
          <a:p>
            <a:pPr>
              <a:lnSpc>
                <a:spcPct val="100000"/>
              </a:lnSpc>
            </a:pPr>
            <a:r>
              <a:rPr lang="en-GB" sz="1100" b="1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19  Niclosamide and </a:t>
            </a:r>
            <a:r>
              <a:rPr lang="en-GB" sz="1100" b="1" kern="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blociclib</a:t>
            </a:r>
            <a:r>
              <a:rPr lang="en-GB" sz="1100" b="1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ct synergistically to reduce the viability of RBE and KKU-M055 cells.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837343" y="1431719"/>
            <a:ext cx="2311378" cy="1845325"/>
            <a:chOff x="4229403" y="5389310"/>
            <a:chExt cx="2311378" cy="1845325"/>
          </a:xfrm>
        </p:grpSpPr>
        <p:pic>
          <p:nvPicPr>
            <p:cNvPr id="44" name="Picture 43" descr="A black and white photo of a rectangular object&#10;&#10;Description automatically generated">
              <a:extLst>
                <a:ext uri="{FF2B5EF4-FFF2-40B4-BE49-F238E27FC236}">
                  <a16:creationId xmlns:a16="http://schemas.microsoft.com/office/drawing/2014/main" id="{DEC8E00A-D204-E39F-F7AA-A5EB7A9AE42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144" t="17245" r="59785" b="76132"/>
            <a:stretch/>
          </p:blipFill>
          <p:spPr>
            <a:xfrm>
              <a:off x="4298980" y="6790140"/>
              <a:ext cx="1257880" cy="41289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9" name="Picture 48" descr="A close-up of a test&#10;&#10;Description automatically generated">
              <a:extLst>
                <a:ext uri="{FF2B5EF4-FFF2-40B4-BE49-F238E27FC236}">
                  <a16:creationId xmlns:a16="http://schemas.microsoft.com/office/drawing/2014/main" id="{70A0C429-03A8-3BA0-AEF3-43F9A81E7E1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380" t="53541" r="41479" b="37634"/>
            <a:stretch/>
          </p:blipFill>
          <p:spPr>
            <a:xfrm>
              <a:off x="4298980" y="6344958"/>
              <a:ext cx="1257880" cy="38882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3" name="Picture 52" descr="A close-up of a test&#10;&#10;Description automatically generated">
              <a:extLst>
                <a:ext uri="{FF2B5EF4-FFF2-40B4-BE49-F238E27FC236}">
                  <a16:creationId xmlns:a16="http://schemas.microsoft.com/office/drawing/2014/main" id="{E7290E08-C657-0898-4317-51F1E87F5DE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286" t="30386" r="44406" b="60236"/>
            <a:stretch/>
          </p:blipFill>
          <p:spPr>
            <a:xfrm>
              <a:off x="4298980" y="5890617"/>
              <a:ext cx="1257880" cy="40125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140" name="Group 139"/>
            <p:cNvGrpSpPr/>
            <p:nvPr/>
          </p:nvGrpSpPr>
          <p:grpSpPr>
            <a:xfrm>
              <a:off x="4229403" y="5389310"/>
              <a:ext cx="2311378" cy="1845325"/>
              <a:chOff x="547856" y="4659538"/>
              <a:chExt cx="2311378" cy="1845325"/>
            </a:xfrm>
          </p:grpSpPr>
          <p:sp>
            <p:nvSpPr>
              <p:cNvPr id="141" name="TextBox 7">
                <a:extLst>
                  <a:ext uri="{FF2B5EF4-FFF2-40B4-BE49-F238E27FC236}">
                    <a16:creationId xmlns:a16="http://schemas.microsoft.com/office/drawing/2014/main" id="{08F5A6E2-D785-E3AB-A979-E9041B5AC87C}"/>
                  </a:ext>
                </a:extLst>
              </p:cNvPr>
              <p:cNvSpPr txBox="1"/>
              <p:nvPr/>
            </p:nvSpPr>
            <p:spPr>
              <a:xfrm>
                <a:off x="547856" y="4918865"/>
                <a:ext cx="176221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900" dirty="0"/>
                  <a:t>    </a:t>
                </a:r>
                <a:r>
                  <a:rPr lang="en-GB" sz="800" dirty="0"/>
                  <a:t>VC    NIC     PAL   COM</a:t>
                </a:r>
              </a:p>
            </p:txBody>
          </p:sp>
          <p:sp>
            <p:nvSpPr>
              <p:cNvPr id="145" name="TextBox 144">
                <a:extLst>
                  <a:ext uri="{FF2B5EF4-FFF2-40B4-BE49-F238E27FC236}">
                    <a16:creationId xmlns:a16="http://schemas.microsoft.com/office/drawing/2014/main" id="{ABC9E646-3449-EEB7-C1A5-577738F33067}"/>
                  </a:ext>
                </a:extLst>
              </p:cNvPr>
              <p:cNvSpPr txBox="1"/>
              <p:nvPr/>
            </p:nvSpPr>
            <p:spPr>
              <a:xfrm>
                <a:off x="1831405" y="6135531"/>
                <a:ext cx="59824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GB" sz="900" dirty="0">
                    <a:latin typeface="Symbol" panose="05050102010706020507" pitchFamily="18" charset="2"/>
                    <a:cs typeface="Arial" panose="020B0604020202020204" pitchFamily="34" charset="0"/>
                  </a:rPr>
                  <a:t> b</a:t>
                </a:r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</a:p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42kDa</a:t>
                </a:r>
              </a:p>
            </p:txBody>
          </p:sp>
          <p:sp>
            <p:nvSpPr>
              <p:cNvPr id="146" name="TextBox 145">
                <a:extLst>
                  <a:ext uri="{FF2B5EF4-FFF2-40B4-BE49-F238E27FC236}">
                    <a16:creationId xmlns:a16="http://schemas.microsoft.com/office/drawing/2014/main" id="{D1A03DFF-84E0-CCAB-7BB2-54ECC456E63B}"/>
                  </a:ext>
                </a:extLst>
              </p:cNvPr>
              <p:cNvSpPr txBox="1"/>
              <p:nvPr/>
            </p:nvSpPr>
            <p:spPr>
              <a:xfrm>
                <a:off x="1831405" y="5681242"/>
                <a:ext cx="87075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 PRH</a:t>
                </a:r>
              </a:p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36kDa </a:t>
                </a:r>
              </a:p>
            </p:txBody>
          </p:sp>
          <p:sp>
            <p:nvSpPr>
              <p:cNvPr id="147" name="TextBox 146">
                <a:extLst>
                  <a:ext uri="{FF2B5EF4-FFF2-40B4-BE49-F238E27FC236}">
                    <a16:creationId xmlns:a16="http://schemas.microsoft.com/office/drawing/2014/main" id="{47AC1123-B605-B8B2-B5C5-36BD5069BD58}"/>
                  </a:ext>
                </a:extLst>
              </p:cNvPr>
              <p:cNvSpPr txBox="1"/>
              <p:nvPr/>
            </p:nvSpPr>
            <p:spPr>
              <a:xfrm>
                <a:off x="879770" y="4659538"/>
                <a:ext cx="68480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RBE cells</a:t>
                </a:r>
              </a:p>
            </p:txBody>
          </p:sp>
          <p:sp>
            <p:nvSpPr>
              <p:cNvPr id="148" name="TextBox 147">
                <a:extLst>
                  <a:ext uri="{FF2B5EF4-FFF2-40B4-BE49-F238E27FC236}">
                    <a16:creationId xmlns:a16="http://schemas.microsoft.com/office/drawing/2014/main" id="{55ACFD59-6976-CB60-5FAF-B5F1621A84F9}"/>
                  </a:ext>
                </a:extLst>
              </p:cNvPr>
              <p:cNvSpPr txBox="1"/>
              <p:nvPr/>
            </p:nvSpPr>
            <p:spPr>
              <a:xfrm>
                <a:off x="1831405" y="5249188"/>
                <a:ext cx="102782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 </a:t>
                </a:r>
                <a:r>
                  <a:rPr lang="en-GB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RB</a:t>
                </a:r>
                <a:endParaRPr lang="en-GB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10kDa</a:t>
                </a:r>
              </a:p>
            </p:txBody>
          </p:sp>
          <p:sp>
            <p:nvSpPr>
              <p:cNvPr id="149" name="Right Bracket 148">
                <a:extLst>
                  <a:ext uri="{FF2B5EF4-FFF2-40B4-BE49-F238E27FC236}">
                    <a16:creationId xmlns:a16="http://schemas.microsoft.com/office/drawing/2014/main" id="{F6F33509-2CA4-1FDC-E64B-A44D72331D05}"/>
                  </a:ext>
                </a:extLst>
              </p:cNvPr>
              <p:cNvSpPr/>
              <p:nvPr/>
            </p:nvSpPr>
            <p:spPr>
              <a:xfrm rot="16200000">
                <a:off x="1279592" y="4351645"/>
                <a:ext cx="45719" cy="1157229"/>
              </a:xfrm>
              <a:prstGeom prst="rightBracket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</p:grpSp>
      <p:grpSp>
        <p:nvGrpSpPr>
          <p:cNvPr id="161" name="Group 160"/>
          <p:cNvGrpSpPr/>
          <p:nvPr/>
        </p:nvGrpSpPr>
        <p:grpSpPr>
          <a:xfrm>
            <a:off x="4188166" y="849170"/>
            <a:ext cx="1377135" cy="1505212"/>
            <a:chOff x="4021377" y="896988"/>
            <a:chExt cx="1841541" cy="1870284"/>
          </a:xfrm>
        </p:grpSpPr>
        <p:sp>
          <p:nvSpPr>
            <p:cNvPr id="163" name="Rectangle 162"/>
            <p:cNvSpPr/>
            <p:nvPr/>
          </p:nvSpPr>
          <p:spPr>
            <a:xfrm>
              <a:off x="4244842" y="896988"/>
              <a:ext cx="1618076" cy="77944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65" name="Rectangle 164"/>
            <p:cNvSpPr/>
            <p:nvPr/>
          </p:nvSpPr>
          <p:spPr>
            <a:xfrm>
              <a:off x="4021377" y="2331065"/>
              <a:ext cx="223465" cy="43620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185" name="TextBox 184"/>
          <p:cNvSpPr txBox="1"/>
          <p:nvPr/>
        </p:nvSpPr>
        <p:spPr>
          <a:xfrm>
            <a:off x="532728" y="1404522"/>
            <a:ext cx="5362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91180"/>
            <a:r>
              <a:rPr lang="en-GB" sz="1000" b="1" dirty="0">
                <a:solidFill>
                  <a:prstClr val="black"/>
                </a:solidFill>
                <a:latin typeface="Calibri"/>
              </a:rPr>
              <a:t>C   </a:t>
            </a:r>
          </a:p>
        </p:txBody>
      </p:sp>
      <p:pic>
        <p:nvPicPr>
          <p:cNvPr id="142" name="Picture 141" descr="A close-up of a test&#10;&#10;Description automatically generated">
            <a:extLst>
              <a:ext uri="{FF2B5EF4-FFF2-40B4-BE49-F238E27FC236}">
                <a16:creationId xmlns:a16="http://schemas.microsoft.com/office/drawing/2014/main" id="{E7290E08-C657-0898-4317-51F1E87F5DE0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651" t="24430" r="16047" b="49200"/>
          <a:stretch/>
        </p:blipFill>
        <p:spPr>
          <a:xfrm>
            <a:off x="1057367" y="3465389"/>
            <a:ext cx="5379829" cy="120514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3" name="Picture 142" descr="A close-up of a test&#10;&#10;Description automatically generated">
            <a:extLst>
              <a:ext uri="{FF2B5EF4-FFF2-40B4-BE49-F238E27FC236}">
                <a16:creationId xmlns:a16="http://schemas.microsoft.com/office/drawing/2014/main" id="{70A0C429-03A8-3BA0-AEF3-43F9A81E7E15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186" t="45166" r="4776" b="13328"/>
          <a:stretch/>
        </p:blipFill>
        <p:spPr>
          <a:xfrm>
            <a:off x="1013324" y="4865846"/>
            <a:ext cx="5619136" cy="1828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4" name="Picture 143" descr="A black and white photo of a rectangular object&#10;&#10;Description automatically generated">
            <a:extLst>
              <a:ext uri="{FF2B5EF4-FFF2-40B4-BE49-F238E27FC236}">
                <a16:creationId xmlns:a16="http://schemas.microsoft.com/office/drawing/2014/main" id="{DEC8E00A-D204-E39F-F7AA-A5EB7A9AE428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894" t="12776" r="12150" b="60610"/>
          <a:stretch/>
        </p:blipFill>
        <p:spPr>
          <a:xfrm>
            <a:off x="1013324" y="6914593"/>
            <a:ext cx="5375787" cy="1659194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5839276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ptos" panose="020B000402020202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6D6DAF2377A7E45918F6D901501FAAB" ma:contentTypeVersion="19" ma:contentTypeDescription="Create a new document." ma:contentTypeScope="" ma:versionID="ee808394dc287a3c3c2e1e9be3c42c07">
  <xsd:schema xmlns:xsd="http://www.w3.org/2001/XMLSchema" xmlns:xs="http://www.w3.org/2001/XMLSchema" xmlns:p="http://schemas.microsoft.com/office/2006/metadata/properties" xmlns:ns3="ac73b9f4-7d57-44da-86d8-a941f08ad392" xmlns:ns4="542045db-3f51-42fe-a4d1-e1a994ce1e28" targetNamespace="http://schemas.microsoft.com/office/2006/metadata/properties" ma:root="true" ma:fieldsID="9465daa86815c60226fd939528628ee6" ns3:_="" ns4:_="">
    <xsd:import namespace="ac73b9f4-7d57-44da-86d8-a941f08ad392"/>
    <xsd:import namespace="542045db-3f51-42fe-a4d1-e1a994ce1e28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DateTaken" minOccurs="0"/>
                <xsd:element ref="ns3:MediaServiceOCR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MediaServiceGenerationTime" minOccurs="0"/>
                <xsd:element ref="ns3:MediaServiceEventHashCode" minOccurs="0"/>
                <xsd:element ref="ns3:_activity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  <xsd:element ref="ns3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c73b9f4-7d57-44da-86d8-a941f08ad39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internalName="MediaServiceAutoTags" ma:readOnly="true">
      <xsd:simpleType>
        <xsd:restriction base="dms:Text"/>
      </xsd:simpleType>
    </xsd:element>
    <xsd:element name="MediaServiceDateTaken" ma:index="11" nillable="true" ma:displayName="MediaServiceDateTaken" ma:hidden="true" ma:internalName="MediaServiceDateTaken" ma:readOnly="true">
      <xsd:simpleType>
        <xsd:restriction base="dms:Text"/>
      </xsd:simple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3" nillable="true" ma:displayName="Location" ma:internalName="MediaServiceLocation" ma:readOnly="true">
      <xsd:simpleType>
        <xsd:restriction base="dms:Text"/>
      </xsd:simpleType>
    </xsd:element>
    <xsd:element name="MediaServiceAutoKeyPoints" ma:index="17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8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MediaServiceGenerationTime" ma:index="20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1" nillable="true" ma:displayName="MediaServiceEventHashCode" ma:hidden="true" ma:internalName="MediaServiceEventHashCode" ma:readOnly="true">
      <xsd:simpleType>
        <xsd:restriction base="dms:Text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ystemTags" ma:index="24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BillingMetadata" ma:index="26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42045db-3f51-42fe-a4d1-e1a994ce1e28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ac73b9f4-7d57-44da-86d8-a941f08ad392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2712E12E-D385-4D4E-9C17-2F672DCAA9F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c73b9f4-7d57-44da-86d8-a941f08ad392"/>
    <ds:schemaRef ds:uri="542045db-3f51-42fe-a4d1-e1a994ce1e2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0551636D-7002-42F3-B7E9-461D434EF607}">
  <ds:schemaRefs>
    <ds:schemaRef ds:uri="http://schemas.microsoft.com/office/2006/metadata/properties"/>
    <ds:schemaRef ds:uri="http://purl.org/dc/terms/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schemas.microsoft.com/office/infopath/2007/PartnerControls"/>
    <ds:schemaRef ds:uri="542045db-3f51-42fe-a4d1-e1a994ce1e28"/>
    <ds:schemaRef ds:uri="ac73b9f4-7d57-44da-86d8-a941f08ad392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3943CB23-51DF-477F-8A82-E91D7E21CEEE}">
  <ds:schemaRefs>
    <ds:schemaRef ds:uri="http://schemas.microsoft.com/sharepoint/v3/contenttype/forms"/>
  </ds:schemaRefs>
</ds:datastoreItem>
</file>

<file path=docMetadata/LabelInfo.xml><?xml version="1.0" encoding="utf-8"?>
<clbl:labelList xmlns:clbl="http://schemas.microsoft.com/office/2020/mipLabelMetadata">
  <clbl:label id="{a17f8ab9-bc70-4901-a8ac-c4b71563637c}" enabled="0" method="" siteId="{a17f8ab9-bc70-4901-a8ac-c4b71563637c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53</TotalTime>
  <Words>419</Words>
  <Application>Microsoft Office PowerPoint</Application>
  <PresentationFormat>A4 Paper (210x297 mm)</PresentationFormat>
  <Paragraphs>121</Paragraphs>
  <Slides>10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7" baseType="lpstr">
      <vt:lpstr>Aptos</vt:lpstr>
      <vt:lpstr>Aptos Display</vt:lpstr>
      <vt:lpstr>Arial</vt:lpstr>
      <vt:lpstr>Calibri</vt:lpstr>
      <vt:lpstr>Symbol</vt:lpstr>
      <vt:lpstr>office theme</vt:lpstr>
      <vt:lpstr>Paintbrush Picture</vt:lpstr>
      <vt:lpstr>PowerPoint Presentation</vt:lpstr>
      <vt:lpstr>PowerPoint Presentation</vt:lpstr>
      <vt:lpstr>PowerPoint Presentation</vt:lpstr>
      <vt:lpstr>Figure S15 Niclosamide and Pablociclib act synergistically to reduce CCA cell viability.</vt:lpstr>
      <vt:lpstr>PowerPoint Presentation</vt:lpstr>
      <vt:lpstr>PowerPoint Presentation</vt:lpstr>
      <vt:lpstr>PowerPoint Presentation</vt:lpstr>
      <vt:lpstr>PowerPoint Presentation</vt:lpstr>
      <vt:lpstr>Figure S19  Niclosamide and Pablociclib act synergistically to reduce the viability of RBE and KKU-M055 cells.</vt:lpstr>
      <vt:lpstr>Figure S19  Niclosamide and Pablociclib act synergistically to reduce the viability of RBE and KKU-M055 cells.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vin Gaston (staff)</dc:creator>
  <cp:lastModifiedBy>MDPI</cp:lastModifiedBy>
  <cp:revision>311</cp:revision>
  <dcterms:created xsi:type="dcterms:W3CDTF">2013-07-15T20:26:40Z</dcterms:created>
  <dcterms:modified xsi:type="dcterms:W3CDTF">2025-11-20T15:52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6D6DAF2377A7E45918F6D901501FAAB</vt:lpwstr>
  </property>
</Properties>
</file>